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drawings/drawing3.xml" ContentType="application/vnd.openxmlformats-officedocument.drawingml.chartshapes+xml"/>
  <Override PartName="/ppt/notesSlides/notesSlide2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73" r:id="rId2"/>
    <p:sldId id="266" r:id="rId3"/>
    <p:sldId id="272" r:id="rId4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33"/>
    <a:srgbClr val="FF00FF"/>
    <a:srgbClr val="00FF00"/>
    <a:srgbClr val="66FF66"/>
    <a:srgbClr val="66FF33"/>
    <a:srgbClr val="33CCFF"/>
    <a:srgbClr val="FFCC00"/>
    <a:srgbClr val="3333FF"/>
    <a:srgbClr val="0000FF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222" autoAdjust="0"/>
    <p:restoredTop sz="95274" autoAdjust="0"/>
  </p:normalViewPr>
  <p:slideViewPr>
    <p:cSldViewPr snapToGrid="0">
      <p:cViewPr varScale="1">
        <p:scale>
          <a:sx n="58" d="100"/>
          <a:sy n="58" d="100"/>
        </p:scale>
        <p:origin x="1956" y="96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chartUserShapes" Target="../drawings/drawing3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5.xlsx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6.xlsx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DA-MB</a:t>
            </a:r>
            <a:r>
              <a:rPr lang="en-US" baseline="0"/>
              <a:t> -436</a:t>
            </a:r>
            <a:endParaRPr lang="en-U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5!$W$2</c:f>
              <c:strCache>
                <c:ptCount val="1"/>
                <c:pt idx="0">
                  <c:v>CyclinD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5!$V$25:$Y$25</c:f>
                <c:numCache>
                  <c:formatCode>General</c:formatCode>
                  <c:ptCount val="4"/>
                  <c:pt idx="0">
                    <c:v>15.66177809357157</c:v>
                  </c:pt>
                  <c:pt idx="1">
                    <c:v>11.574043465889643</c:v>
                  </c:pt>
                  <c:pt idx="2">
                    <c:v>8.7078706532307368</c:v>
                  </c:pt>
                  <c:pt idx="3">
                    <c:v>6.6382423357052147</c:v>
                  </c:pt>
                </c:numCache>
              </c:numRef>
            </c:plus>
            <c:minus>
              <c:numRef>
                <c:f>Sheet15!$V$25:$Y$25</c:f>
                <c:numCache>
                  <c:formatCode>General</c:formatCode>
                  <c:ptCount val="4"/>
                  <c:pt idx="0">
                    <c:v>15.66177809357157</c:v>
                  </c:pt>
                  <c:pt idx="1">
                    <c:v>11.574043465889643</c:v>
                  </c:pt>
                  <c:pt idx="2">
                    <c:v>8.7078706532307368</c:v>
                  </c:pt>
                  <c:pt idx="3">
                    <c:v>6.63824233570521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5!$AF$3:$AI$3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&amp;CISPLAIN</c:v>
                </c:pt>
              </c:strCache>
            </c:strRef>
          </c:cat>
          <c:val>
            <c:numRef>
              <c:f>Sheet15!$V$11:$Y$11</c:f>
              <c:numCache>
                <c:formatCode>General</c:formatCode>
                <c:ptCount val="4"/>
                <c:pt idx="0">
                  <c:v>99.999999999999986</c:v>
                </c:pt>
                <c:pt idx="1">
                  <c:v>111.34848381489303</c:v>
                </c:pt>
                <c:pt idx="2">
                  <c:v>66.771395990235092</c:v>
                </c:pt>
                <c:pt idx="3">
                  <c:v>68.6767294027985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1D-4112-8997-F43ADC86E4D8}"/>
            </c:ext>
          </c:extLst>
        </c:ser>
        <c:ser>
          <c:idx val="1"/>
          <c:order val="1"/>
          <c:tx>
            <c:strRef>
              <c:f>Sheet15!$AB$2</c:f>
              <c:strCache>
                <c:ptCount val="1"/>
                <c:pt idx="0">
                  <c:v>P2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5!$AA$25:$AD$25</c:f>
                <c:numCache>
                  <c:formatCode>General</c:formatCode>
                  <c:ptCount val="4"/>
                  <c:pt idx="0">
                    <c:v>43.569404471474435</c:v>
                  </c:pt>
                  <c:pt idx="1">
                    <c:v>37.403531331545899</c:v>
                  </c:pt>
                  <c:pt idx="2">
                    <c:v>41.001669788880754</c:v>
                  </c:pt>
                  <c:pt idx="3">
                    <c:v>83.07828561659619</c:v>
                  </c:pt>
                </c:numCache>
              </c:numRef>
            </c:plus>
            <c:minus>
              <c:numRef>
                <c:f>Sheet15!$AA$25:$AD$25</c:f>
                <c:numCache>
                  <c:formatCode>General</c:formatCode>
                  <c:ptCount val="4"/>
                  <c:pt idx="0">
                    <c:v>43.569404471474435</c:v>
                  </c:pt>
                  <c:pt idx="1">
                    <c:v>37.403531331545899</c:v>
                  </c:pt>
                  <c:pt idx="2">
                    <c:v>41.001669788880754</c:v>
                  </c:pt>
                  <c:pt idx="3">
                    <c:v>83.078285616596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5!$AF$3:$AI$3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&amp;CISPLAIN</c:v>
                </c:pt>
              </c:strCache>
            </c:strRef>
          </c:cat>
          <c:val>
            <c:numRef>
              <c:f>Sheet15!$AA$24:$AD$24</c:f>
              <c:numCache>
                <c:formatCode>General</c:formatCode>
                <c:ptCount val="4"/>
                <c:pt idx="0">
                  <c:v>100</c:v>
                </c:pt>
                <c:pt idx="1">
                  <c:v>140.68867171961855</c:v>
                </c:pt>
                <c:pt idx="2">
                  <c:v>327.70949428283558</c:v>
                </c:pt>
                <c:pt idx="3">
                  <c:v>360.6019918879075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1D-4112-8997-F43ADC86E4D8}"/>
            </c:ext>
          </c:extLst>
        </c:ser>
        <c:ser>
          <c:idx val="2"/>
          <c:order val="2"/>
          <c:tx>
            <c:strRef>
              <c:f>Sheet15!$AG$15</c:f>
              <c:strCache>
                <c:ptCount val="1"/>
                <c:pt idx="0">
                  <c:v>P16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5!$AF$25:$AI$25</c:f>
                <c:numCache>
                  <c:formatCode>General</c:formatCode>
                  <c:ptCount val="4"/>
                  <c:pt idx="0">
                    <c:v>19.868416658175985</c:v>
                  </c:pt>
                  <c:pt idx="1">
                    <c:v>13.30570123378156</c:v>
                  </c:pt>
                  <c:pt idx="2">
                    <c:v>9.9504644055519087</c:v>
                  </c:pt>
                  <c:pt idx="3">
                    <c:v>13.441775056652869</c:v>
                  </c:pt>
                </c:numCache>
              </c:numRef>
            </c:plus>
            <c:minus>
              <c:numRef>
                <c:f>Sheet15!$AF$25:$AI$25</c:f>
                <c:numCache>
                  <c:formatCode>General</c:formatCode>
                  <c:ptCount val="4"/>
                  <c:pt idx="0">
                    <c:v>19.868416658175985</c:v>
                  </c:pt>
                  <c:pt idx="1">
                    <c:v>13.30570123378156</c:v>
                  </c:pt>
                  <c:pt idx="2">
                    <c:v>9.9504644055519087</c:v>
                  </c:pt>
                  <c:pt idx="3">
                    <c:v>13.44177505665286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5!$AF$3:$AI$3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&amp;CISPLAIN</c:v>
                </c:pt>
              </c:strCache>
            </c:strRef>
          </c:cat>
          <c:val>
            <c:numRef>
              <c:f>Sheet15!$AF$24:$AI$24</c:f>
              <c:numCache>
                <c:formatCode>General</c:formatCode>
                <c:ptCount val="4"/>
                <c:pt idx="0">
                  <c:v>100</c:v>
                </c:pt>
                <c:pt idx="1">
                  <c:v>56.544981647699366</c:v>
                </c:pt>
                <c:pt idx="2">
                  <c:v>84.733484125232735</c:v>
                </c:pt>
                <c:pt idx="3">
                  <c:v>54.7210390858958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D1D-4112-8997-F43ADC86E4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7706336"/>
        <c:axId val="737703840"/>
      </c:barChart>
      <c:catAx>
        <c:axId val="737706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737703840"/>
        <c:crosses val="autoZero"/>
        <c:auto val="1"/>
        <c:lblAlgn val="ctr"/>
        <c:lblOffset val="100"/>
        <c:noMultiLvlLbl val="0"/>
      </c:catAx>
      <c:valAx>
        <c:axId val="737703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7377063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DA-MB</a:t>
            </a:r>
            <a:r>
              <a:rPr lang="en-US" baseline="0"/>
              <a:t> -231</a:t>
            </a:r>
            <a:endParaRPr lang="en-US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5!$W$2</c:f>
              <c:strCache>
                <c:ptCount val="1"/>
                <c:pt idx="0">
                  <c:v>CyclinD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5!$V$12:$Y$12</c:f>
                <c:numCache>
                  <c:formatCode>General</c:formatCode>
                  <c:ptCount val="4"/>
                  <c:pt idx="0">
                    <c:v>24.602619247332228</c:v>
                  </c:pt>
                  <c:pt idx="1">
                    <c:v>16.488618706603894</c:v>
                  </c:pt>
                  <c:pt idx="2">
                    <c:v>9.9508325180024162</c:v>
                  </c:pt>
                  <c:pt idx="3">
                    <c:v>12.348567347001998</c:v>
                  </c:pt>
                </c:numCache>
              </c:numRef>
            </c:plus>
            <c:minus>
              <c:numRef>
                <c:f>Sheet15!$V$12:$Y$12</c:f>
                <c:numCache>
                  <c:formatCode>General</c:formatCode>
                  <c:ptCount val="4"/>
                  <c:pt idx="0">
                    <c:v>24.602619247332228</c:v>
                  </c:pt>
                  <c:pt idx="1">
                    <c:v>16.488618706603894</c:v>
                  </c:pt>
                  <c:pt idx="2">
                    <c:v>9.9508325180024162</c:v>
                  </c:pt>
                  <c:pt idx="3">
                    <c:v>12.348567347001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5!$AF$3:$AI$3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&amp;CISPLAIN</c:v>
                </c:pt>
              </c:strCache>
            </c:strRef>
          </c:cat>
          <c:val>
            <c:numRef>
              <c:f>Sheet15!$V$11:$Y$11</c:f>
              <c:numCache>
                <c:formatCode>General</c:formatCode>
                <c:ptCount val="4"/>
                <c:pt idx="0">
                  <c:v>99.999999999999986</c:v>
                </c:pt>
                <c:pt idx="1">
                  <c:v>111.34848381489303</c:v>
                </c:pt>
                <c:pt idx="2">
                  <c:v>66.771395990235092</c:v>
                </c:pt>
                <c:pt idx="3">
                  <c:v>68.6767294027985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67-45BE-8F24-5DD4BBAF9430}"/>
            </c:ext>
          </c:extLst>
        </c:ser>
        <c:ser>
          <c:idx val="1"/>
          <c:order val="1"/>
          <c:tx>
            <c:strRef>
              <c:f>Sheet15!$AB$2</c:f>
              <c:strCache>
                <c:ptCount val="1"/>
                <c:pt idx="0">
                  <c:v>P21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5!$AA$12:$AD$12</c:f>
                <c:numCache>
                  <c:formatCode>General</c:formatCode>
                  <c:ptCount val="4"/>
                  <c:pt idx="0">
                    <c:v>19.293091936596902</c:v>
                  </c:pt>
                  <c:pt idx="1">
                    <c:v>15.855124816536172</c:v>
                  </c:pt>
                  <c:pt idx="2">
                    <c:v>88.64050914597631</c:v>
                  </c:pt>
                  <c:pt idx="3">
                    <c:v>22.156153579819161</c:v>
                  </c:pt>
                </c:numCache>
              </c:numRef>
            </c:plus>
            <c:minus>
              <c:numRef>
                <c:f>Sheet15!$AA$12:$AD$12</c:f>
                <c:numCache>
                  <c:formatCode>General</c:formatCode>
                  <c:ptCount val="4"/>
                  <c:pt idx="0">
                    <c:v>19.293091936596902</c:v>
                  </c:pt>
                  <c:pt idx="1">
                    <c:v>15.855124816536172</c:v>
                  </c:pt>
                  <c:pt idx="2">
                    <c:v>88.64050914597631</c:v>
                  </c:pt>
                  <c:pt idx="3">
                    <c:v>22.1561535798191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5!$AF$3:$AI$3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&amp;CISPLAIN</c:v>
                </c:pt>
              </c:strCache>
            </c:strRef>
          </c:cat>
          <c:val>
            <c:numRef>
              <c:f>Sheet15!$AA$11:$AD$11</c:f>
              <c:numCache>
                <c:formatCode>General</c:formatCode>
                <c:ptCount val="4"/>
                <c:pt idx="0">
                  <c:v>100</c:v>
                </c:pt>
                <c:pt idx="1">
                  <c:v>83.321316486234096</c:v>
                </c:pt>
                <c:pt idx="2">
                  <c:v>112.55196281200837</c:v>
                </c:pt>
                <c:pt idx="3">
                  <c:v>129.133355841510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F67-45BE-8F24-5DD4BBAF9430}"/>
            </c:ext>
          </c:extLst>
        </c:ser>
        <c:ser>
          <c:idx val="2"/>
          <c:order val="2"/>
          <c:tx>
            <c:strRef>
              <c:f>Sheet15!$AG$2</c:f>
              <c:strCache>
                <c:ptCount val="1"/>
                <c:pt idx="0">
                  <c:v>P16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5!$AF$12:$AI$12</c:f>
                <c:numCache>
                  <c:formatCode>General</c:formatCode>
                  <c:ptCount val="4"/>
                  <c:pt idx="0">
                    <c:v>79.304915785278425</c:v>
                  </c:pt>
                  <c:pt idx="1">
                    <c:v>10.835893864255128</c:v>
                  </c:pt>
                  <c:pt idx="2">
                    <c:v>79.88865871080074</c:v>
                  </c:pt>
                  <c:pt idx="3">
                    <c:v>23.363103287321756</c:v>
                  </c:pt>
                </c:numCache>
              </c:numRef>
            </c:plus>
            <c:minus>
              <c:numRef>
                <c:f>Sheet15!$AF$12:$AI$12</c:f>
                <c:numCache>
                  <c:formatCode>General</c:formatCode>
                  <c:ptCount val="4"/>
                  <c:pt idx="0">
                    <c:v>79.304915785278425</c:v>
                  </c:pt>
                  <c:pt idx="1">
                    <c:v>10.835893864255128</c:v>
                  </c:pt>
                  <c:pt idx="2">
                    <c:v>79.88865871080074</c:v>
                  </c:pt>
                  <c:pt idx="3">
                    <c:v>23.3631032873217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5!$AF$3:$AI$3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&amp;CISPLAIN</c:v>
                </c:pt>
              </c:strCache>
            </c:strRef>
          </c:cat>
          <c:val>
            <c:numRef>
              <c:f>Sheet15!$AF$11:$AI$11</c:f>
              <c:numCache>
                <c:formatCode>General</c:formatCode>
                <c:ptCount val="4"/>
                <c:pt idx="0">
                  <c:v>100</c:v>
                </c:pt>
                <c:pt idx="1">
                  <c:v>13.658742156714942</c:v>
                </c:pt>
                <c:pt idx="2">
                  <c:v>116.30441976958565</c:v>
                </c:pt>
                <c:pt idx="3">
                  <c:v>24.7515513095619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F67-45BE-8F24-5DD4BBAF943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37706336"/>
        <c:axId val="737703840"/>
      </c:barChart>
      <c:catAx>
        <c:axId val="73770633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737703840"/>
        <c:crosses val="autoZero"/>
        <c:auto val="1"/>
        <c:lblAlgn val="ctr"/>
        <c:lblOffset val="100"/>
        <c:noMultiLvlLbl val="0"/>
      </c:catAx>
      <c:valAx>
        <c:axId val="737703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7377063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941112896403895"/>
          <c:y val="7.4074183498462939E-2"/>
          <c:w val="0.67561025730128521"/>
          <c:h val="0.7908180227471566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3CC33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jc1_analysis_mda231_cis_vpa_170!$O$43:$R$43</c:f>
                <c:numCache>
                  <c:formatCode>General</c:formatCode>
                  <c:ptCount val="4"/>
                  <c:pt idx="0">
                    <c:v>1.1729748505402844</c:v>
                  </c:pt>
                  <c:pt idx="1">
                    <c:v>1.17556227681339</c:v>
                  </c:pt>
                  <c:pt idx="2">
                    <c:v>9.6978507928303443</c:v>
                  </c:pt>
                  <c:pt idx="3">
                    <c:v>14.850335237517927</c:v>
                  </c:pt>
                </c:numCache>
              </c:numRef>
            </c:plus>
            <c:minus>
              <c:numRef>
                <c:f>jc1_analysis_mda231_cis_vpa_170!$O$43:$R$43</c:f>
                <c:numCache>
                  <c:formatCode>General</c:formatCode>
                  <c:ptCount val="4"/>
                  <c:pt idx="0">
                    <c:v>1.1729748505402844</c:v>
                  </c:pt>
                  <c:pt idx="1">
                    <c:v>1.17556227681339</c:v>
                  </c:pt>
                  <c:pt idx="2">
                    <c:v>9.6978507928303443</c:v>
                  </c:pt>
                  <c:pt idx="3">
                    <c:v>14.850335237517927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jc1_analysis_mda231_cis_vpa_170!$O$25:$R$25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&amp; Cisplatin</c:v>
                </c:pt>
              </c:strCache>
            </c:strRef>
          </c:cat>
          <c:val>
            <c:numRef>
              <c:f>jc1_analysis_mda231_cis_vpa_170!$O$42:$R$42</c:f>
              <c:numCache>
                <c:formatCode>General</c:formatCode>
                <c:ptCount val="4"/>
                <c:pt idx="0">
                  <c:v>3.4579999999999997</c:v>
                </c:pt>
                <c:pt idx="1">
                  <c:v>9.3433333333333319</c:v>
                </c:pt>
                <c:pt idx="2">
                  <c:v>31.875</c:v>
                </c:pt>
                <c:pt idx="3">
                  <c:v>31.828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87-4A6C-A66D-EA19156A91A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535865824"/>
        <c:axId val="1535859168"/>
      </c:barChart>
      <c:catAx>
        <c:axId val="15358658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>
                <a:lumMod val="65000"/>
                <a:lumOff val="3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1535859168"/>
        <c:crosses val="autoZero"/>
        <c:auto val="1"/>
        <c:lblAlgn val="ctr"/>
        <c:lblOffset val="100"/>
        <c:noMultiLvlLbl val="0"/>
      </c:catAx>
      <c:valAx>
        <c:axId val="1535859168"/>
        <c:scaling>
          <c:orientation val="minMax"/>
          <c:max val="6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ysClr val="windowText" lastClr="000000"/>
                    </a:solidFill>
                  </a:rPr>
                  <a:t>% JC-1 green</a:t>
                </a:r>
                <a:r>
                  <a:rPr lang="en-US" b="1" baseline="0">
                    <a:solidFill>
                      <a:sysClr val="windowText" lastClr="000000"/>
                    </a:solidFill>
                  </a:rPr>
                  <a:t> monomer</a:t>
                </a:r>
                <a:endParaRPr lang="en-US" b="1">
                  <a:solidFill>
                    <a:sysClr val="windowText" lastClr="000000"/>
                  </a:solidFill>
                </a:endParaRPr>
              </a:p>
            </c:rich>
          </c:tx>
          <c:layout>
            <c:manualLayout>
              <c:xMode val="edge"/>
              <c:yMode val="edge"/>
              <c:x val="0.10103902186468933"/>
              <c:y val="0.1520812436694571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>
                <a:lumMod val="65000"/>
                <a:lumOff val="3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1535865824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33CC33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'lipid peroxidation'!$M$3:$M$6</c:f>
                <c:numCache>
                  <c:formatCode>General</c:formatCode>
                  <c:ptCount val="4"/>
                  <c:pt idx="0">
                    <c:v>17.603610376546978</c:v>
                  </c:pt>
                  <c:pt idx="1">
                    <c:v>10.70811449325234</c:v>
                  </c:pt>
                  <c:pt idx="2">
                    <c:v>29.316037570979439</c:v>
                  </c:pt>
                  <c:pt idx="3">
                    <c:v>17.593648206731608</c:v>
                  </c:pt>
                </c:numCache>
              </c:numRef>
            </c:plus>
            <c:minus>
              <c:numRef>
                <c:f>'lipid peroxidation'!$M$3:$M$6</c:f>
                <c:numCache>
                  <c:formatCode>General</c:formatCode>
                  <c:ptCount val="4"/>
                  <c:pt idx="0">
                    <c:v>17.603610376546978</c:v>
                  </c:pt>
                  <c:pt idx="1">
                    <c:v>10.70811449325234</c:v>
                  </c:pt>
                  <c:pt idx="2">
                    <c:v>29.316037570979439</c:v>
                  </c:pt>
                  <c:pt idx="3">
                    <c:v>17.593648206731608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lipid peroxidation'!$K$3:$K$6</c:f>
              <c:strCache>
                <c:ptCount val="4"/>
                <c:pt idx="0">
                  <c:v>Vehicle</c:v>
                </c:pt>
                <c:pt idx="1">
                  <c:v> VPA</c:v>
                </c:pt>
                <c:pt idx="2">
                  <c:v> Cisplatin</c:v>
                </c:pt>
                <c:pt idx="3">
                  <c:v> VPA &amp;  Cisplatin</c:v>
                </c:pt>
              </c:strCache>
            </c:strRef>
          </c:cat>
          <c:val>
            <c:numRef>
              <c:f>'lipid peroxidation'!$L$3:$L$6</c:f>
              <c:numCache>
                <c:formatCode>0.00</c:formatCode>
                <c:ptCount val="4"/>
                <c:pt idx="0">
                  <c:v>92.560454345122935</c:v>
                </c:pt>
                <c:pt idx="1">
                  <c:v>81.67478091257469</c:v>
                </c:pt>
                <c:pt idx="2">
                  <c:v>164.16439069422552</c:v>
                </c:pt>
                <c:pt idx="3">
                  <c:v>161.913434388917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5C3-476C-AB02-ECD9BF15520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4576512"/>
        <c:axId val="84594688"/>
      </c:barChart>
      <c:catAx>
        <c:axId val="845765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84594688"/>
        <c:crosses val="autoZero"/>
        <c:auto val="1"/>
        <c:lblAlgn val="ctr"/>
        <c:lblOffset val="100"/>
        <c:noMultiLvlLbl val="0"/>
      </c:catAx>
      <c:valAx>
        <c:axId val="84594688"/>
        <c:scaling>
          <c:orientation val="minMax"/>
          <c:max val="3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>
                    <a:solidFill>
                      <a:sysClr val="windowText" lastClr="000000"/>
                    </a:solidFill>
                  </a:rPr>
                  <a:t>MFI (% of control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845765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/>
      </a:pPr>
      <a:endParaRPr lang="he-IL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33CC33"/>
            </a:solidFill>
            <a:ln w="19050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ros_activity_pexp4_per_dox_cis_!$H$27,ros_activity_pexp4_per_dox_cis_!$J$27,ros_activity_pexp4_per_dox_cis_!$L$27,ros_activity_pexp4_per_dox_cis_!$N$27)</c:f>
                <c:numCache>
                  <c:formatCode>General</c:formatCode>
                  <c:ptCount val="4"/>
                  <c:pt idx="0">
                    <c:v>22.719921086836425</c:v>
                  </c:pt>
                  <c:pt idx="1">
                    <c:v>18.15624536462542</c:v>
                  </c:pt>
                  <c:pt idx="2">
                    <c:v>23.097366853993265</c:v>
                  </c:pt>
                  <c:pt idx="3">
                    <c:v>74.101455945769203</c:v>
                  </c:pt>
                </c:numCache>
              </c:numRef>
            </c:plus>
            <c:minus>
              <c:numRef>
                <c:f>(ros_activity_pexp4_per_dox_cis_!$H$27,ros_activity_pexp4_per_dox_cis_!$J$27,ros_activity_pexp4_per_dox_cis_!$L$27,ros_activity_pexp4_per_dox_cis_!$N$27)</c:f>
                <c:numCache>
                  <c:formatCode>General</c:formatCode>
                  <c:ptCount val="4"/>
                  <c:pt idx="0">
                    <c:v>22.719921086836425</c:v>
                  </c:pt>
                  <c:pt idx="1">
                    <c:v>18.15624536462542</c:v>
                  </c:pt>
                  <c:pt idx="2">
                    <c:v>23.097366853993265</c:v>
                  </c:pt>
                  <c:pt idx="3">
                    <c:v>74.101455945769203</c:v>
                  </c:pt>
                </c:numCache>
              </c:numRef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ros_activity_pexp4_per_dox_cis_!$P$4:$S$4</c:f>
              <c:strCache>
                <c:ptCount val="4"/>
                <c:pt idx="0">
                  <c:v>Vehicle</c:v>
                </c:pt>
                <c:pt idx="1">
                  <c:v>VPA</c:v>
                </c:pt>
                <c:pt idx="2">
                  <c:v>Cisplatin</c:v>
                </c:pt>
                <c:pt idx="3">
                  <c:v>VPA &amp; Cisplatin</c:v>
                </c:pt>
              </c:strCache>
            </c:strRef>
          </c:cat>
          <c:val>
            <c:numRef>
              <c:f>(ros_activity_pexp4_per_dox_cis_!$H$26,ros_activity_pexp4_per_dox_cis_!$J$26,ros_activity_pexp4_per_dox_cis_!$L$26,ros_activity_pexp4_per_dox_cis_!$N$26)</c:f>
              <c:numCache>
                <c:formatCode>General</c:formatCode>
                <c:ptCount val="4"/>
                <c:pt idx="0">
                  <c:v>94.495662789317876</c:v>
                </c:pt>
                <c:pt idx="1">
                  <c:v>105.11664021709494</c:v>
                </c:pt>
                <c:pt idx="2">
                  <c:v>204.61807838169747</c:v>
                </c:pt>
                <c:pt idx="3">
                  <c:v>197.846080594498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04-4DA1-A8C1-EA82826560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951488"/>
        <c:axId val="80614528"/>
      </c:barChart>
      <c:catAx>
        <c:axId val="759514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80614528"/>
        <c:crosses val="autoZero"/>
        <c:auto val="1"/>
        <c:lblAlgn val="ctr"/>
        <c:lblOffset val="100"/>
        <c:noMultiLvlLbl val="0"/>
      </c:catAx>
      <c:valAx>
        <c:axId val="8061452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 b="1">
                    <a:solidFill>
                      <a:schemeClr val="tx1"/>
                    </a:solidFill>
                  </a:rPr>
                  <a:t>MFI</a:t>
                </a:r>
                <a:r>
                  <a:rPr lang="en-US" sz="1000" b="1" baseline="0">
                    <a:solidFill>
                      <a:schemeClr val="tx1"/>
                    </a:solidFill>
                  </a:rPr>
                  <a:t> (Rerlative to control)</a:t>
                </a:r>
                <a:endParaRPr lang="en-US" sz="1000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5.8634690987067653E-2"/>
              <c:y val="5.1510307573586156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75951488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  <c:userShapes r:id="rId4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Viability assay</a:t>
            </a:r>
            <a:r>
              <a:rPr lang="en-US" baseline="0" dirty="0"/>
              <a:t> Organoi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25400">
              <a:noFill/>
            </a:ln>
            <a:effectLst/>
          </c:spPr>
          <c:invertIfNegative val="0"/>
          <c:cat>
            <c:strRef>
              <c:f>Sheet1!$D$38:$D$44</c:f>
              <c:strCache>
                <c:ptCount val="7"/>
                <c:pt idx="0">
                  <c:v>Control</c:v>
                </c:pt>
                <c:pt idx="1">
                  <c:v>Cisplatin</c:v>
                </c:pt>
                <c:pt idx="2">
                  <c:v>Taxol</c:v>
                </c:pt>
                <c:pt idx="3">
                  <c:v>Disulfiram</c:v>
                </c:pt>
                <c:pt idx="4">
                  <c:v>Valproic acid</c:v>
                </c:pt>
                <c:pt idx="5">
                  <c:v>Entinostat</c:v>
                </c:pt>
                <c:pt idx="6">
                  <c:v>Talazoparib</c:v>
                </c:pt>
              </c:strCache>
            </c:strRef>
          </c:cat>
          <c:val>
            <c:numRef>
              <c:f>Sheet1!$G$38:$G$44</c:f>
              <c:numCache>
                <c:formatCode>General</c:formatCode>
                <c:ptCount val="7"/>
                <c:pt idx="0">
                  <c:v>100</c:v>
                </c:pt>
                <c:pt idx="1">
                  <c:v>85.484867201976542</c:v>
                </c:pt>
                <c:pt idx="2">
                  <c:v>47.39551163269509</c:v>
                </c:pt>
                <c:pt idx="3">
                  <c:v>54.642783611282688</c:v>
                </c:pt>
                <c:pt idx="4">
                  <c:v>47.848466131356808</c:v>
                </c:pt>
                <c:pt idx="5">
                  <c:v>46.736668725550757</c:v>
                </c:pt>
                <c:pt idx="6">
                  <c:v>34.91867407864938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E3-45E9-A883-0FC4A7BC4F0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6553759"/>
        <c:axId val="116554175"/>
      </c:barChart>
      <c:catAx>
        <c:axId val="1165537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116554175"/>
        <c:crosses val="autoZero"/>
        <c:auto val="1"/>
        <c:lblAlgn val="ctr"/>
        <c:lblOffset val="100"/>
        <c:noMultiLvlLbl val="1"/>
      </c:catAx>
      <c:valAx>
        <c:axId val="11655417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%Viabil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1165537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ALDH1A1 mRNA</a:t>
            </a:r>
            <a:r>
              <a:rPr lang="en-US" baseline="0"/>
              <a:t> expression</a:t>
            </a:r>
            <a:endParaRPr lang="en-US"/>
          </a:p>
        </c:rich>
      </c:tx>
      <c:layout>
        <c:manualLayout>
          <c:xMode val="edge"/>
          <c:yMode val="edge"/>
          <c:x val="0.29577993416852882"/>
          <c:y val="4.1762936660424306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title>
    <c:autoTitleDeleted val="0"/>
    <c:plotArea>
      <c:layout>
        <c:manualLayout>
          <c:layoutTarget val="inner"/>
          <c:xMode val="edge"/>
          <c:yMode val="edge"/>
          <c:x val="0.17297091863517064"/>
          <c:y val="9.6333422718445E-2"/>
          <c:w val="0.71315527559055114"/>
          <c:h val="0.76605315976369825"/>
        </c:manualLayout>
      </c:layout>
      <c:barChart>
        <c:barDir val="col"/>
        <c:grouping val="clustered"/>
        <c:varyColors val="0"/>
        <c:ser>
          <c:idx val="0"/>
          <c:order val="0"/>
          <c:tx>
            <c:v>w/o VPA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ALDH1A1_ORG_6REPEATS!$K$46,ALDH1A1_ORG_6REPEATS!$M$46,ALDH1A1_ORG_6REPEATS!$O$46)</c:f>
                <c:numCache>
                  <c:formatCode>General</c:formatCode>
                  <c:ptCount val="3"/>
                  <c:pt idx="0">
                    <c:v>41.459970670981896</c:v>
                  </c:pt>
                  <c:pt idx="1">
                    <c:v>61.766308240288467</c:v>
                  </c:pt>
                  <c:pt idx="2">
                    <c:v>11.446416598884293</c:v>
                  </c:pt>
                </c:numCache>
              </c:numRef>
            </c:plus>
            <c:minus>
              <c:numRef>
                <c:f>(ALDH1A1_ORG_6REPEATS!$M$59,ALDH1A1_ORG_6REPEATS!$O$59,ALDH1A1_ORG_6REPEATS!$Q$59,ALDH1A1_ORG_6REPEATS!$K$46,ALDH1A1_ORG_6REPEATS!$M$46,ALDH1A1_ORG_6REPEATS!$O$46)</c:f>
                <c:numCache>
                  <c:formatCode>General</c:formatCode>
                  <c:ptCount val="6"/>
                  <c:pt idx="0">
                    <c:v>65.101286625324605</c:v>
                  </c:pt>
                  <c:pt idx="1">
                    <c:v>40.69718445751397</c:v>
                  </c:pt>
                  <c:pt idx="2">
                    <c:v>34.114180886229342</c:v>
                  </c:pt>
                  <c:pt idx="3">
                    <c:v>41.459970670981896</c:v>
                  </c:pt>
                  <c:pt idx="4">
                    <c:v>61.766308240288467</c:v>
                  </c:pt>
                  <c:pt idx="5">
                    <c:v>11.4464165988842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(ALDH1A1_ORG_6REPEATS!$M$50,ALDH1A1_ORG_6REPEATS!$O$50,ALDH1A1_ORG_6REPEATS!$Q$50)</c:f>
              <c:strCache>
                <c:ptCount val="3"/>
                <c:pt idx="0">
                  <c:v>Vehicle</c:v>
                </c:pt>
                <c:pt idx="1">
                  <c:v>Cisplatin</c:v>
                </c:pt>
                <c:pt idx="2">
                  <c:v>paclitaxel</c:v>
                </c:pt>
              </c:strCache>
            </c:strRef>
          </c:cat>
          <c:val>
            <c:numRef>
              <c:f>(ALDH1A1_ORG_6REPEATS!$M$58,ALDH1A1_ORG_6REPEATS!$O$58,ALDH1A1_ORG_6REPEATS!$Q$58)</c:f>
              <c:numCache>
                <c:formatCode>General</c:formatCode>
                <c:ptCount val="3"/>
                <c:pt idx="0">
                  <c:v>100</c:v>
                </c:pt>
                <c:pt idx="1">
                  <c:v>261.44120513035153</c:v>
                </c:pt>
                <c:pt idx="2">
                  <c:v>43.8205488033715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26D-4F3D-8AD6-560972D002A3}"/>
            </c:ext>
          </c:extLst>
        </c:ser>
        <c:ser>
          <c:idx val="1"/>
          <c:order val="1"/>
          <c:tx>
            <c:v>w/VPA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ALDH1A1_ORG_6REPEATS!$L$46,ALDH1A1_ORG_6REPEATS!$N$46,ALDH1A1_ORG_6REPEATS!$P$46)</c:f>
                <c:numCache>
                  <c:formatCode>General</c:formatCode>
                  <c:ptCount val="3"/>
                  <c:pt idx="0">
                    <c:v>82.907813268423496</c:v>
                  </c:pt>
                  <c:pt idx="1">
                    <c:v>116.65871993358454</c:v>
                  </c:pt>
                  <c:pt idx="2">
                    <c:v>90.610506454045876</c:v>
                  </c:pt>
                </c:numCache>
              </c:numRef>
            </c:plus>
            <c:minus>
              <c:numRef>
                <c:f>(ALDH1A1_ORG_6REPEATS!$N$59,ALDH1A1_ORG_6REPEATS!$P$59,ALDH1A1_ORG_6REPEATS!$R$59,ALDH1A1_ORG_6REPEATS!$L$46,ALDH1A1_ORG_6REPEATS!$N$46,ALDH1A1_ORG_6REPEATS!$P$46)</c:f>
                <c:numCache>
                  <c:formatCode>General</c:formatCode>
                  <c:ptCount val="6"/>
                  <c:pt idx="0">
                    <c:v>57.682681828658858</c:v>
                  </c:pt>
                  <c:pt idx="1">
                    <c:v>108.42155761016075</c:v>
                  </c:pt>
                  <c:pt idx="2">
                    <c:v>73.892940573959208</c:v>
                  </c:pt>
                  <c:pt idx="3">
                    <c:v>82.907813268423496</c:v>
                  </c:pt>
                  <c:pt idx="4">
                    <c:v>116.65871993358454</c:v>
                  </c:pt>
                  <c:pt idx="5">
                    <c:v>90.61050645404587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ALDH1A1_ORG_6REPEATS!$L$45,ALDH1A1_ORG_6REPEATS!$N$45,ALDH1A1_ORG_6REPEATS!$P$45)</c:f>
              <c:numCache>
                <c:formatCode>General</c:formatCode>
                <c:ptCount val="3"/>
                <c:pt idx="0">
                  <c:v>139.78993723009859</c:v>
                </c:pt>
                <c:pt idx="1">
                  <c:v>203.37215278241979</c:v>
                </c:pt>
                <c:pt idx="2">
                  <c:v>45.3052532270229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26D-4F3D-8AD6-560972D002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04699567"/>
        <c:axId val="285758639"/>
      </c:barChart>
      <c:catAx>
        <c:axId val="210469956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285758639"/>
        <c:crosses val="autoZero"/>
        <c:auto val="1"/>
        <c:lblAlgn val="ctr"/>
        <c:lblOffset val="100"/>
        <c:noMultiLvlLbl val="0"/>
      </c:catAx>
      <c:valAx>
        <c:axId val="28575863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elative</a:t>
                </a:r>
                <a:r>
                  <a:rPr lang="en-US" baseline="0"/>
                  <a:t> transcript level (% of Control)</a:t>
                </a:r>
                <a:endParaRPr lang="en-US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he-IL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he-IL"/>
          </a:p>
        </c:txPr>
        <c:crossAx val="210469956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8275139862759899"/>
          <c:y val="0.92825189905229788"/>
          <c:w val="0.24417070866141732"/>
          <c:h val="6.96599302796128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he-IL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he-IL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5454</cdr:x>
      <cdr:y>0.21026</cdr:y>
    </cdr:from>
    <cdr:to>
      <cdr:x>0.85563</cdr:x>
      <cdr:y>0.21151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2657ED21-4FCB-44DD-B3C5-74B4256492B9}"/>
            </a:ext>
          </a:extLst>
        </cdr:cNvPr>
        <cdr:cNvCxnSpPr/>
      </cdr:nvCxnSpPr>
      <cdr:spPr>
        <a:xfrm xmlns:a="http://schemas.openxmlformats.org/drawingml/2006/main">
          <a:off x="1183580" y="426996"/>
          <a:ext cx="1672846" cy="2551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4089</cdr:x>
      <cdr:y>0.36491</cdr:y>
    </cdr:from>
    <cdr:to>
      <cdr:x>0.64159</cdr:x>
      <cdr:y>0.3657</cdr:y>
    </cdr:to>
    <cdr:cxnSp macro="">
      <cdr:nvCxnSpPr>
        <cdr:cNvPr id="5" name="Straight Connector 4">
          <a:extLst xmlns:a="http://schemas.openxmlformats.org/drawingml/2006/main">
            <a:ext uri="{FF2B5EF4-FFF2-40B4-BE49-F238E27FC236}">
              <a16:creationId xmlns:a16="http://schemas.microsoft.com/office/drawing/2014/main" id="{F8CF5ABE-2EE5-4CE4-B8C1-CEE86BBD6D1B}"/>
            </a:ext>
          </a:extLst>
        </cdr:cNvPr>
        <cdr:cNvCxnSpPr/>
      </cdr:nvCxnSpPr>
      <cdr:spPr>
        <a:xfrm xmlns:a="http://schemas.openxmlformats.org/drawingml/2006/main">
          <a:off x="1138020" y="741070"/>
          <a:ext cx="1003850" cy="1608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</cdr:x>
      <cdr:y>0.12527</cdr:y>
    </cdr:from>
    <cdr:to>
      <cdr:x>0.86177</cdr:x>
      <cdr:y>0.127</cdr:y>
    </cdr:to>
    <cdr:cxnSp macro="">
      <cdr:nvCxnSpPr>
        <cdr:cNvPr id="8" name="Straight Connector 7">
          <a:extLst xmlns:a="http://schemas.openxmlformats.org/drawingml/2006/main">
            <a:ext uri="{FF2B5EF4-FFF2-40B4-BE49-F238E27FC236}">
              <a16:creationId xmlns:a16="http://schemas.microsoft.com/office/drawing/2014/main" id="{2657ED21-4FCB-44DD-B3C5-74B4256492B9}"/>
            </a:ext>
          </a:extLst>
        </cdr:cNvPr>
        <cdr:cNvCxnSpPr/>
      </cdr:nvCxnSpPr>
      <cdr:spPr>
        <a:xfrm xmlns:a="http://schemas.openxmlformats.org/drawingml/2006/main">
          <a:off x="1669194" y="254411"/>
          <a:ext cx="1207719" cy="3504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1535</cdr:x>
      <cdr:y>0</cdr:y>
    </cdr:from>
    <cdr:to>
      <cdr:x>0.10672</cdr:x>
      <cdr:y>0.1245</cdr:y>
    </cdr:to>
    <cdr:sp macro="" textlink="">
      <cdr:nvSpPr>
        <cdr:cNvPr id="2" name="TextBox 32"/>
        <cdr:cNvSpPr txBox="1"/>
      </cdr:nvSpPr>
      <cdr:spPr>
        <a:xfrm xmlns:a="http://schemas.openxmlformats.org/drawingml/2006/main">
          <a:off x="52947" y="0"/>
          <a:ext cx="315162" cy="276999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1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b="1" dirty="0"/>
            <a:t>F</a:t>
          </a:r>
          <a:endParaRPr lang="he-IL" sz="1200" b="1" dirty="0"/>
        </a:p>
      </cdr:txBody>
    </cdr:sp>
  </cdr:relSizeAnchor>
  <cdr:relSizeAnchor xmlns:cdr="http://schemas.openxmlformats.org/drawingml/2006/chartDrawing">
    <cdr:from>
      <cdr:x>0.29126</cdr:x>
      <cdr:y>0.10565</cdr:y>
    </cdr:from>
    <cdr:to>
      <cdr:x>0.64654</cdr:x>
      <cdr:y>0.10565</cdr:y>
    </cdr:to>
    <cdr:cxnSp macro="">
      <cdr:nvCxnSpPr>
        <cdr:cNvPr id="3" name="Straight Connector 2">
          <a:extLst xmlns:a="http://schemas.openxmlformats.org/drawingml/2006/main">
            <a:ext uri="{FF2B5EF4-FFF2-40B4-BE49-F238E27FC236}">
              <a16:creationId xmlns:a16="http://schemas.microsoft.com/office/drawing/2014/main" id="{81378FD3-ADB8-4E59-811F-2AB6D01DD907}"/>
            </a:ext>
          </a:extLst>
        </cdr:cNvPr>
        <cdr:cNvCxnSpPr/>
      </cdr:nvCxnSpPr>
      <cdr:spPr>
        <a:xfrm xmlns:a="http://schemas.openxmlformats.org/drawingml/2006/main">
          <a:off x="1004649" y="219334"/>
          <a:ext cx="1225449" cy="0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6095</cdr:x>
      <cdr:y>1</cdr:y>
    </cdr:from>
    <cdr:to>
      <cdr:x>1</cdr:x>
      <cdr:y>1</cdr:y>
    </cdr:to>
    <cdr:cxnSp macro="">
      <cdr:nvCxnSpPr>
        <cdr:cNvPr id="5" name="Straight Connector 4">
          <a:extLst xmlns:a="http://schemas.openxmlformats.org/drawingml/2006/main">
            <a:ext uri="{FF2B5EF4-FFF2-40B4-BE49-F238E27FC236}">
              <a16:creationId xmlns:a16="http://schemas.microsoft.com/office/drawing/2014/main" id="{9C3DF2A1-ACD9-4F07-92A4-F40205CF9B1F}"/>
            </a:ext>
          </a:extLst>
        </cdr:cNvPr>
        <cdr:cNvCxnSpPr/>
      </cdr:nvCxnSpPr>
      <cdr:spPr>
        <a:xfrm xmlns:a="http://schemas.openxmlformats.org/drawingml/2006/main">
          <a:off x="4495209" y="3110865"/>
          <a:ext cx="1859350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4028</cdr:x>
      <cdr:y>0.01659</cdr:y>
    </cdr:from>
    <cdr:to>
      <cdr:x>0.55972</cdr:x>
      <cdr:y>0.08931</cdr:y>
    </cdr:to>
    <cdr:sp macro="" textlink="">
      <cdr:nvSpPr>
        <cdr:cNvPr id="6" name="TextBox 1"/>
        <cdr:cNvSpPr txBox="1"/>
      </cdr:nvSpPr>
      <cdr:spPr>
        <a:xfrm xmlns:a="http://schemas.openxmlformats.org/drawingml/2006/main">
          <a:off x="1518653" y="34450"/>
          <a:ext cx="411991" cy="15096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e-IL" sz="1500" b="1" dirty="0">
              <a:latin typeface="Calibri"/>
            </a:rPr>
            <a:t>*</a:t>
          </a:r>
          <a:endParaRPr lang="he-IL" sz="1500" b="1" dirty="0"/>
        </a:p>
      </cdr:txBody>
    </cdr:sp>
  </cdr:relSizeAnchor>
  <cdr:relSizeAnchor xmlns:cdr="http://schemas.openxmlformats.org/drawingml/2006/chartDrawing">
    <cdr:from>
      <cdr:x>0.28884</cdr:x>
      <cdr:y>0.17012</cdr:y>
    </cdr:from>
    <cdr:to>
      <cdr:x>0.86557</cdr:x>
      <cdr:y>0.17013</cdr:y>
    </cdr:to>
    <cdr:cxnSp macro="">
      <cdr:nvCxnSpPr>
        <cdr:cNvPr id="7" name="Straight Connector 6">
          <a:extLst xmlns:a="http://schemas.openxmlformats.org/drawingml/2006/main">
            <a:ext uri="{FF2B5EF4-FFF2-40B4-BE49-F238E27FC236}">
              <a16:creationId xmlns:a16="http://schemas.microsoft.com/office/drawing/2014/main" id="{7604F3CA-83A4-4F95-AF3C-EFBBD1A7F450}"/>
            </a:ext>
          </a:extLst>
        </cdr:cNvPr>
        <cdr:cNvCxnSpPr/>
      </cdr:nvCxnSpPr>
      <cdr:spPr>
        <a:xfrm xmlns:a="http://schemas.openxmlformats.org/drawingml/2006/main" flipV="1">
          <a:off x="912320" y="351753"/>
          <a:ext cx="1821668" cy="20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2655</cdr:x>
      <cdr:y>0.07599</cdr:y>
    </cdr:from>
    <cdr:to>
      <cdr:x>0.64599</cdr:x>
      <cdr:y>0.11327</cdr:y>
    </cdr:to>
    <cdr:sp macro="" textlink="">
      <cdr:nvSpPr>
        <cdr:cNvPr id="12" name="TextBox 1"/>
        <cdr:cNvSpPr txBox="1"/>
      </cdr:nvSpPr>
      <cdr:spPr>
        <a:xfrm xmlns:a="http://schemas.openxmlformats.org/drawingml/2006/main">
          <a:off x="1663163" y="157128"/>
          <a:ext cx="377265" cy="7708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e-IL" sz="1500" b="1" dirty="0">
              <a:latin typeface="Calibri"/>
            </a:rPr>
            <a:t>*</a:t>
          </a:r>
          <a:endParaRPr lang="he-IL" sz="1500" b="1" dirty="0"/>
        </a:p>
      </cdr:txBody>
    </cdr:sp>
  </cdr:relSizeAnchor>
  <cdr:relSizeAnchor xmlns:cdr="http://schemas.openxmlformats.org/drawingml/2006/chartDrawing">
    <cdr:from>
      <cdr:x>0.45302</cdr:x>
      <cdr:y>0.22651</cdr:y>
    </cdr:from>
    <cdr:to>
      <cdr:x>0.66175</cdr:x>
      <cdr:y>0.22651</cdr:y>
    </cdr:to>
    <cdr:cxnSp macro="">
      <cdr:nvCxnSpPr>
        <cdr:cNvPr id="13" name="Straight Connector 12">
          <a:extLst xmlns:a="http://schemas.openxmlformats.org/drawingml/2006/main">
            <a:ext uri="{FF2B5EF4-FFF2-40B4-BE49-F238E27FC236}">
              <a16:creationId xmlns:a16="http://schemas.microsoft.com/office/drawing/2014/main" id="{8A901939-9140-4E9E-9228-CAFECEBA88FE}"/>
            </a:ext>
          </a:extLst>
        </cdr:cNvPr>
        <cdr:cNvCxnSpPr/>
      </cdr:nvCxnSpPr>
      <cdr:spPr>
        <a:xfrm xmlns:a="http://schemas.openxmlformats.org/drawingml/2006/main">
          <a:off x="1562589" y="470236"/>
          <a:ext cx="720000" cy="0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52654</cdr:x>
      <cdr:y>0.13675</cdr:y>
    </cdr:from>
    <cdr:to>
      <cdr:x>0.64599</cdr:x>
      <cdr:y>0.20947</cdr:y>
    </cdr:to>
    <cdr:sp macro="" textlink="">
      <cdr:nvSpPr>
        <cdr:cNvPr id="14" name="TextBox 1"/>
        <cdr:cNvSpPr txBox="1"/>
      </cdr:nvSpPr>
      <cdr:spPr>
        <a:xfrm xmlns:a="http://schemas.openxmlformats.org/drawingml/2006/main">
          <a:off x="1663132" y="282753"/>
          <a:ext cx="377296" cy="15036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e-IL" sz="1500" b="1" dirty="0">
              <a:latin typeface="Calibri"/>
            </a:rPr>
            <a:t>*</a:t>
          </a:r>
          <a:endParaRPr lang="he-IL" sz="1500" b="1" dirty="0"/>
        </a:p>
      </cdr:txBody>
    </cdr:sp>
  </cdr:relSizeAnchor>
  <cdr:relSizeAnchor xmlns:cdr="http://schemas.openxmlformats.org/drawingml/2006/chartDrawing">
    <cdr:from>
      <cdr:x>0.46911</cdr:x>
      <cdr:y>0.30061</cdr:y>
    </cdr:from>
    <cdr:to>
      <cdr:x>0.88407</cdr:x>
      <cdr:y>0.30061</cdr:y>
    </cdr:to>
    <cdr:cxnSp macro="">
      <cdr:nvCxnSpPr>
        <cdr:cNvPr id="15" name="Straight Connector 14">
          <a:extLst xmlns:a="http://schemas.openxmlformats.org/drawingml/2006/main">
            <a:ext uri="{FF2B5EF4-FFF2-40B4-BE49-F238E27FC236}">
              <a16:creationId xmlns:a16="http://schemas.microsoft.com/office/drawing/2014/main" id="{DA1E335E-1AC7-40E8-9B66-27000AC8D7E9}"/>
            </a:ext>
          </a:extLst>
        </cdr:cNvPr>
        <cdr:cNvCxnSpPr/>
      </cdr:nvCxnSpPr>
      <cdr:spPr>
        <a:xfrm xmlns:a="http://schemas.openxmlformats.org/drawingml/2006/main" flipV="1">
          <a:off x="1481738" y="621585"/>
          <a:ext cx="1310696" cy="1"/>
        </a:xfrm>
        <a:prstGeom xmlns:a="http://schemas.openxmlformats.org/drawingml/2006/main" prst="line">
          <a:avLst/>
        </a:prstGeom>
        <a:ln xmlns:a="http://schemas.openxmlformats.org/drawingml/2006/main"/>
      </cdr:spPr>
      <cdr:style>
        <a:lnRef xmlns:a="http://schemas.openxmlformats.org/drawingml/2006/main" idx="3">
          <a:schemeClr val="dk1"/>
        </a:lnRef>
        <a:fillRef xmlns:a="http://schemas.openxmlformats.org/drawingml/2006/main" idx="0">
          <a:schemeClr val="dk1"/>
        </a:fillRef>
        <a:effectRef xmlns:a="http://schemas.openxmlformats.org/drawingml/2006/main" idx="2">
          <a:schemeClr val="dk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64048</cdr:x>
      <cdr:y>0.2127</cdr:y>
    </cdr:from>
    <cdr:to>
      <cdr:x>0.75992</cdr:x>
      <cdr:y>0.28976</cdr:y>
    </cdr:to>
    <cdr:sp macro="" textlink="">
      <cdr:nvSpPr>
        <cdr:cNvPr id="18" name="TextBox 1"/>
        <cdr:cNvSpPr txBox="1"/>
      </cdr:nvSpPr>
      <cdr:spPr>
        <a:xfrm xmlns:a="http://schemas.openxmlformats.org/drawingml/2006/main">
          <a:off x="2023026" y="439801"/>
          <a:ext cx="377265" cy="1593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e-IL" sz="1500" b="1" dirty="0">
              <a:latin typeface="Calibri"/>
            </a:rPr>
            <a:t>*</a:t>
          </a:r>
          <a:endParaRPr lang="he-IL" sz="15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38843</cdr:x>
      <cdr:y>0.99933</cdr:y>
    </cdr:from>
    <cdr:to>
      <cdr:x>1</cdr:x>
      <cdr:y>1</cdr:y>
    </cdr:to>
    <cdr:cxnSp macro="">
      <cdr:nvCxnSpPr>
        <cdr:cNvPr id="2" name="Straight Connector 1">
          <a:extLst xmlns:a="http://schemas.openxmlformats.org/drawingml/2006/main">
            <a:ext uri="{FF2B5EF4-FFF2-40B4-BE49-F238E27FC236}">
              <a16:creationId xmlns:a16="http://schemas.microsoft.com/office/drawing/2014/main" id="{8040064E-5E0A-402B-91BD-7E441CECB5F9}"/>
            </a:ext>
          </a:extLst>
        </cdr:cNvPr>
        <cdr:cNvCxnSpPr/>
      </cdr:nvCxnSpPr>
      <cdr:spPr>
        <a:xfrm xmlns:a="http://schemas.openxmlformats.org/drawingml/2006/main" flipV="1">
          <a:off x="4469024" y="2718899"/>
          <a:ext cx="1848093" cy="1289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4138</cdr:x>
      <cdr:y>0.11502</cdr:y>
    </cdr:from>
    <cdr:to>
      <cdr:x>0.58216</cdr:x>
      <cdr:y>0.18071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333803" y="221183"/>
          <a:ext cx="425420" cy="12634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1"/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he-IL" sz="1500" b="1" dirty="0">
              <a:latin typeface="Calibri"/>
            </a:rPr>
            <a:t>*</a:t>
          </a:r>
          <a:endParaRPr lang="he-IL" sz="1500" b="1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6503A1F6-E7D4-4EB4-9C4E-033DAA6B26F2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32470A80-EBC5-4882-B98C-B8D0AD44C007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020474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470A80-EBC5-4882-B98C-B8D0AD44C007}" type="slidenum">
              <a:rPr lang="he-IL" smtClean="0"/>
              <a:t>2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498716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e-IL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470A80-EBC5-4882-B98C-B8D0AD44C007}" type="slidenum">
              <a:rPr lang="he-IL" smtClean="0"/>
              <a:t>3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137925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658951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6737297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07832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77532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76178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22328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1374465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46489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680706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19166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76094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615A19-C291-4B73-938C-F883DD4EEFF9}" type="datetimeFigureOut">
              <a:rPr lang="he-IL" smtClean="0"/>
              <a:t>ט'/אלול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515897-38C9-486C-AAEC-79453DF21ED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838496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png"/><Relationship Id="rId18" Type="http://schemas.microsoft.com/office/2007/relationships/hdphoto" Target="../media/hdphoto3.wdp"/><Relationship Id="rId3" Type="http://schemas.openxmlformats.org/officeDocument/2006/relationships/chart" Target="../charts/chart3.xml"/><Relationship Id="rId7" Type="http://schemas.openxmlformats.org/officeDocument/2006/relationships/image" Target="../media/image3.png"/><Relationship Id="rId12" Type="http://schemas.openxmlformats.org/officeDocument/2006/relationships/image" Target="../media/image7.png"/><Relationship Id="rId17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6" Type="http://schemas.microsoft.com/office/2007/relationships/hdphoto" Target="../media/hdphoto2.wdp"/><Relationship Id="rId20" Type="http://schemas.microsoft.com/office/2007/relationships/hdphoto" Target="../media/hdphoto4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png"/><Relationship Id="rId11" Type="http://schemas.openxmlformats.org/officeDocument/2006/relationships/chart" Target="../charts/chart5.xml"/><Relationship Id="rId5" Type="http://schemas.openxmlformats.org/officeDocument/2006/relationships/image" Target="../media/image1.png"/><Relationship Id="rId15" Type="http://schemas.openxmlformats.org/officeDocument/2006/relationships/image" Target="../media/image9.png"/><Relationship Id="rId10" Type="http://schemas.openxmlformats.org/officeDocument/2006/relationships/image" Target="../media/image6.png"/><Relationship Id="rId19" Type="http://schemas.openxmlformats.org/officeDocument/2006/relationships/image" Target="../media/image11.png"/><Relationship Id="rId4" Type="http://schemas.openxmlformats.org/officeDocument/2006/relationships/chart" Target="../charts/chart4.xml"/><Relationship Id="rId9" Type="http://schemas.openxmlformats.org/officeDocument/2006/relationships/image" Target="../media/image5.png"/><Relationship Id="rId1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4" Type="http://schemas.openxmlformats.org/officeDocument/2006/relationships/chart" Target="../charts/char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3385741"/>
              </p:ext>
            </p:extLst>
          </p:nvPr>
        </p:nvGraphicFramePr>
        <p:xfrm>
          <a:off x="321859" y="665551"/>
          <a:ext cx="5915025" cy="2087940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707445">
                  <a:extLst>
                    <a:ext uri="{9D8B030D-6E8A-4147-A177-3AD203B41FA5}">
                      <a16:colId xmlns:a16="http://schemas.microsoft.com/office/drawing/2014/main" val="3384678442"/>
                    </a:ext>
                  </a:extLst>
                </a:gridCol>
                <a:gridCol w="2478240">
                  <a:extLst>
                    <a:ext uri="{9D8B030D-6E8A-4147-A177-3AD203B41FA5}">
                      <a16:colId xmlns:a16="http://schemas.microsoft.com/office/drawing/2014/main" val="632718854"/>
                    </a:ext>
                  </a:extLst>
                </a:gridCol>
                <a:gridCol w="2729340">
                  <a:extLst>
                    <a:ext uri="{9D8B030D-6E8A-4147-A177-3AD203B41FA5}">
                      <a16:colId xmlns:a16="http://schemas.microsoft.com/office/drawing/2014/main" val="604977851"/>
                    </a:ext>
                  </a:extLst>
                </a:gridCol>
              </a:tblGrid>
              <a:tr h="163760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NAME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orward primer (5’-3’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everse primer (3’-5’)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3896275284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GLUT1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effectLst/>
                        </a:rPr>
                        <a:t>CGTCGCCACCCGCGTAC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ACTCCTCGATCACCTTCTGGG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1303166459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BP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GGTTTGCTGCGGTAAT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CTGGACTGTTCTTCACTCTT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1509125294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LDH1A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GAAGGAGATAAGGAGGA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ATCAGCCAACTTGTATAATA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1110710854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CT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ACCGTACAGCAACTATACG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AATGGTCGCCTCTTGTAG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1097818863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MCT4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TCATCACGGGGTTGGGT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GCTTGCTGAAGTAGCGGT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1943685327"/>
                  </a:ext>
                </a:extLst>
              </a:tr>
              <a:tr h="204700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LDH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 AGGCTACACATCCTGGGCTA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CCAAAATGCAAGGAACACT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3048397655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LDHB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ATGGATTTTGGGGGAACA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ACACCTGCCACATTCACA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1552281953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p16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CCAGAGGCAGTAACCATG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CTGTAGGACCTTCGGTGA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498392899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Cyclin D1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CCTGAGGAGCCCCAACAA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GCTTCGATCTGCTCCTGGC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3328129343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LDH1A2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gcattcacagggtctactga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tgcctccaagttccagagt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2047038396"/>
                  </a:ext>
                </a:extLst>
              </a:tr>
              <a:tr h="171948"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LDH1A3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effectLst/>
                        </a:rPr>
                        <a:t>aacccctgcatcgtgtgt</a:t>
                      </a:r>
                      <a:endParaRPr lang="en-US" sz="9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 err="1">
                          <a:effectLst/>
                        </a:rPr>
                        <a:t>tggttgaagaacactccctga</a:t>
                      </a:r>
                      <a:endParaRPr lang="en-US" sz="9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8954" marR="58954" marT="0" marB="0" anchor="b"/>
                </a:tc>
                <a:extLst>
                  <a:ext uri="{0D108BD9-81ED-4DB2-BD59-A6C34878D82A}">
                    <a16:rowId xmlns:a16="http://schemas.microsoft.com/office/drawing/2014/main" val="1995875782"/>
                  </a:ext>
                </a:extLst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321859" y="283425"/>
            <a:ext cx="4424312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/>
              <a:t>Supplementary Table 1. Sequence of primers used for RT-PCR studies</a:t>
            </a:r>
            <a:endParaRPr lang="he-IL" sz="1000" dirty="0"/>
          </a:p>
        </p:txBody>
      </p:sp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8130325"/>
              </p:ext>
            </p:extLst>
          </p:nvPr>
        </p:nvGraphicFramePr>
        <p:xfrm>
          <a:off x="1596934" y="5179418"/>
          <a:ext cx="3880757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9508091"/>
              </p:ext>
            </p:extLst>
          </p:nvPr>
        </p:nvGraphicFramePr>
        <p:xfrm>
          <a:off x="1596934" y="3154675"/>
          <a:ext cx="3973286" cy="20247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Rectangle 10"/>
          <p:cNvSpPr/>
          <p:nvPr/>
        </p:nvSpPr>
        <p:spPr>
          <a:xfrm>
            <a:off x="444137" y="7219404"/>
            <a:ext cx="62788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a typeface="Arial Unicode MS"/>
              </a:rPr>
              <a:t>Supplementary Figure 1</a:t>
            </a:r>
            <a:r>
              <a:rPr lang="en-US" sz="1200" dirty="0">
                <a:solidFill>
                  <a:srgbClr val="000000"/>
                </a:solidFill>
                <a:ea typeface="Arial Unicode MS"/>
              </a:rPr>
              <a:t>. </a:t>
            </a:r>
            <a:r>
              <a:rPr lang="en-US" sz="1200" b="1" dirty="0" smtClean="0">
                <a:solidFill>
                  <a:srgbClr val="000000"/>
                </a:solidFill>
                <a:ea typeface="Arial Unicode MS"/>
              </a:rPr>
              <a:t>Cyclin D1, P21 and P16 RNA expression</a:t>
            </a:r>
            <a:r>
              <a:rPr lang="en-US" sz="1200" dirty="0" smtClean="0">
                <a:solidFill>
                  <a:srgbClr val="000000"/>
                </a:solidFill>
                <a:ea typeface="Arial Unicode MS"/>
              </a:rPr>
              <a:t>. Real-time </a:t>
            </a:r>
            <a:r>
              <a:rPr lang="en-US" sz="1200" dirty="0">
                <a:solidFill>
                  <a:srgbClr val="000000"/>
                </a:solidFill>
                <a:ea typeface="Arial Unicode MS"/>
              </a:rPr>
              <a:t>PCR of CyclinD1, p21 and p16. (A)MDA231 cells were treated with VPA, cisplatin, or both for 72 hr. (B) Same for MDA-MB-436. Results are presented as percent of control (mean ± SD); *p &lt; 0.05 (N=6/group).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36023" y="3154675"/>
            <a:ext cx="6705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A.</a:t>
            </a:r>
            <a:endParaRPr lang="he-IL" dirty="0"/>
          </a:p>
        </p:txBody>
      </p:sp>
      <p:sp>
        <p:nvSpPr>
          <p:cNvPr id="13" name="TextBox 12"/>
          <p:cNvSpPr txBox="1"/>
          <p:nvPr/>
        </p:nvSpPr>
        <p:spPr>
          <a:xfrm>
            <a:off x="926374" y="5395936"/>
            <a:ext cx="670560" cy="369332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dirty="0"/>
              <a:t>B.</a:t>
            </a:r>
            <a:endParaRPr lang="he-IL" dirty="0"/>
          </a:p>
        </p:txBody>
      </p:sp>
    </p:spTree>
    <p:extLst>
      <p:ext uri="{BB962C8B-B14F-4D97-AF65-F5344CB8AC3E}">
        <p14:creationId xmlns:p14="http://schemas.microsoft.com/office/powerpoint/2010/main" val="224548880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4" name="Chart 4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604983"/>
              </p:ext>
            </p:extLst>
          </p:nvPr>
        </p:nvGraphicFramePr>
        <p:xfrm>
          <a:off x="3065403" y="2499204"/>
          <a:ext cx="3338388" cy="20308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1" name="Chart 8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02806255"/>
              </p:ext>
            </p:extLst>
          </p:nvPr>
        </p:nvGraphicFramePr>
        <p:xfrm>
          <a:off x="3390652" y="5178324"/>
          <a:ext cx="3158615" cy="206771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0" name="Rectangle 19"/>
          <p:cNvSpPr/>
          <p:nvPr/>
        </p:nvSpPr>
        <p:spPr>
          <a:xfrm>
            <a:off x="383796" y="9178053"/>
            <a:ext cx="6207340" cy="2246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Supplementary Figure 2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. 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Effect of VPA, cisplatin and their combination on ROS levels, mitochondrial membrane potential, and lipid peroxidation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. MDA-MB-231 cells were treated with 1 mM VPA, 10 </a:t>
            </a:r>
            <a:r>
              <a:rPr lang="en-US" sz="1000" dirty="0">
                <a:solidFill>
                  <a:srgbClr val="000000"/>
                </a:solidFill>
                <a:latin typeface="Calibri" panose="020F0502020204030204" pitchFamily="34" charset="0"/>
                <a:ea typeface="Arial Unicode MS"/>
                <a:cs typeface="Calibri" panose="020F0502020204030204" pitchFamily="34" charset="0"/>
              </a:rPr>
              <a:t>µ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M cisplatin, or their combination for 72 hr. DMSO (0.01%) served as control. 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(A) 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ROS levels. ROS levels were detected using the ﬂuorescein-based H2DCFH-DA reagent and measured by ﬂow cytometry. Shown are representative flow cytometry histograms show ROS levels. 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(B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) Quantification of the data shown in (A). The bar graph shows means ± SD of ROS levels (n=6/</a:t>
            </a:r>
            <a:r>
              <a:rPr lang="en-US" sz="1000" dirty="0"/>
              <a:t>treatment group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). 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(C) 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Mitochondrial membrane depolarization. Depolarization was assessed by JC-1 dye and measured by ﬂow cytometry. Representative flow cytometry plots show JC-1 red fluorescent J-aggregate levels vs. JC-1 green fluorescence monomer levels. 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(D) 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Quantification of the data shown in (C).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 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The bar graph shows means ± SD of JC-1 red fluorescent J-aggregates (n=6/treatment group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Arial Unicode MS"/>
                <a:cs typeface="+mj-cs"/>
              </a:rPr>
              <a:t>). 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(E) 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Lipid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ea typeface="Arial Unicode MS"/>
                <a:cs typeface="+mj-cs"/>
              </a:rPr>
              <a:t>peroxidation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:</a:t>
            </a:r>
            <a:r>
              <a:rPr lang="en-US" sz="1000" b="1" dirty="0" smtClean="0">
                <a:solidFill>
                  <a:srgbClr val="000000"/>
                </a:solidFill>
                <a:ea typeface="Arial Unicode MS"/>
                <a:cs typeface="+mj-cs"/>
              </a:rPr>
              <a:t> 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Lipid peroxidation levels were detected using the Click-</a:t>
            </a:r>
            <a:r>
              <a:rPr lang="en-US" sz="1000" dirty="0" err="1">
                <a:solidFill>
                  <a:srgbClr val="000000"/>
                </a:solidFill>
                <a:ea typeface="Arial Unicode MS"/>
                <a:cs typeface="+mj-cs"/>
              </a:rPr>
              <a:t>iT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® Lipid Peroxidation Imaging Kit and measured by ﬂow cytometry. Shown are representative flow cytometry histograms evaluating lipid peroxidation levels. 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(F) </a:t>
            </a:r>
            <a:r>
              <a:rPr lang="en-US" sz="1000" dirty="0">
                <a:solidFill>
                  <a:srgbClr val="000000"/>
                </a:solidFill>
                <a:ea typeface="Arial Unicode MS"/>
              </a:rPr>
              <a:t>Quantification of the data shown in (E). The b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ar graph shows means ± SD of lipid peroxidation levels (n=6/treatment group</a:t>
            </a:r>
            <a:r>
              <a:rPr lang="en-US" sz="1000" dirty="0">
                <a:solidFill>
                  <a:srgbClr val="000000"/>
                </a:solidFill>
                <a:latin typeface="Times New Roman" panose="02020603050405020304" pitchFamily="18" charset="0"/>
                <a:ea typeface="Arial Unicode MS"/>
                <a:cs typeface="+mj-cs"/>
              </a:rPr>
              <a:t>).</a:t>
            </a:r>
            <a:r>
              <a:rPr lang="en-US" sz="1000" b="1" dirty="0">
                <a:solidFill>
                  <a:srgbClr val="000000"/>
                </a:solidFill>
                <a:ea typeface="Arial Unicode MS"/>
                <a:cs typeface="+mj-cs"/>
              </a:rPr>
              <a:t> (G) </a:t>
            </a:r>
            <a:r>
              <a:rPr lang="en-US" sz="1000" dirty="0" smtClean="0">
                <a:solidFill>
                  <a:srgbClr val="000000"/>
                </a:solidFill>
                <a:ea typeface="Arial Unicode MS"/>
                <a:cs typeface="+mj-cs"/>
              </a:rPr>
              <a:t>Representative</a:t>
            </a:r>
            <a:r>
              <a:rPr lang="en-US" sz="1000" b="1" dirty="0" smtClean="0">
                <a:solidFill>
                  <a:srgbClr val="000000"/>
                </a:solidFill>
                <a:ea typeface="Arial Unicode MS"/>
                <a:cs typeface="+mj-cs"/>
              </a:rPr>
              <a:t> </a:t>
            </a:r>
            <a:r>
              <a:rPr lang="en-US" sz="1000" dirty="0" smtClean="0">
                <a:solidFill>
                  <a:srgbClr val="000000"/>
                </a:solidFill>
                <a:cs typeface="+mj-cs"/>
              </a:rPr>
              <a:t>C</a:t>
            </a:r>
            <a:r>
              <a:rPr lang="en-US" sz="1000" dirty="0" smtClean="0">
                <a:solidFill>
                  <a:srgbClr val="000000"/>
                </a:solidFill>
                <a:ea typeface="Arial Unicode MS"/>
                <a:cs typeface="+mj-cs"/>
              </a:rPr>
              <a:t>onfocal images </a:t>
            </a:r>
            <a:r>
              <a:rPr lang="en-US" sz="1000" dirty="0">
                <a:solidFill>
                  <a:srgbClr val="000000"/>
                </a:solidFill>
                <a:ea typeface="Arial Unicode MS"/>
                <a:cs typeface="+mj-cs"/>
              </a:rPr>
              <a:t>of treated MDA-MB-231 cells, showing lipid peroxidation (X60 objective</a:t>
            </a:r>
            <a:r>
              <a:rPr lang="en-US" sz="1000" dirty="0" smtClean="0">
                <a:solidFill>
                  <a:srgbClr val="000000"/>
                </a:solidFill>
                <a:ea typeface="Arial Unicode MS"/>
                <a:cs typeface="+mj-cs"/>
              </a:rPr>
              <a:t>). </a:t>
            </a:r>
            <a:r>
              <a:rPr lang="en-US" sz="1000" dirty="0" err="1" smtClean="0">
                <a:solidFill>
                  <a:srgbClr val="000000"/>
                </a:solidFill>
                <a:ea typeface="Arial Unicode MS"/>
                <a:cs typeface="+mj-cs"/>
              </a:rPr>
              <a:t>Dapi</a:t>
            </a:r>
            <a:r>
              <a:rPr lang="en-US" sz="1000" dirty="0" smtClean="0">
                <a:solidFill>
                  <a:srgbClr val="000000"/>
                </a:solidFill>
                <a:ea typeface="Arial Unicode MS"/>
                <a:cs typeface="+mj-cs"/>
              </a:rPr>
              <a:t> staining is blue and lipid peroxidation is in green.</a:t>
            </a:r>
            <a:endParaRPr lang="en-US" sz="1000" dirty="0">
              <a:solidFill>
                <a:srgbClr val="000000"/>
              </a:solidFill>
              <a:highlight>
                <a:srgbClr val="FFFF00"/>
              </a:highlight>
              <a:ea typeface="Arial Unicode MS"/>
              <a:cs typeface="+mj-cs"/>
            </a:endParaRPr>
          </a:p>
        </p:txBody>
      </p:sp>
      <p:grpSp>
        <p:nvGrpSpPr>
          <p:cNvPr id="38" name="Group 37"/>
          <p:cNvGrpSpPr/>
          <p:nvPr/>
        </p:nvGrpSpPr>
        <p:grpSpPr>
          <a:xfrm>
            <a:off x="55821" y="402529"/>
            <a:ext cx="3767055" cy="4684650"/>
            <a:chOff x="309846" y="5795994"/>
            <a:chExt cx="3665024" cy="4276951"/>
          </a:xfrm>
        </p:grpSpPr>
        <p:grpSp>
          <p:nvGrpSpPr>
            <p:cNvPr id="19" name="Group 18"/>
            <p:cNvGrpSpPr/>
            <p:nvPr/>
          </p:nvGrpSpPr>
          <p:grpSpPr>
            <a:xfrm>
              <a:off x="455605" y="5896485"/>
              <a:ext cx="3519265" cy="264996"/>
              <a:chOff x="442604" y="427468"/>
              <a:chExt cx="5090102" cy="378975"/>
            </a:xfrm>
          </p:grpSpPr>
          <p:sp>
            <p:nvSpPr>
              <p:cNvPr id="23" name="TextBox 2"/>
              <p:cNvSpPr txBox="1"/>
              <p:nvPr/>
            </p:nvSpPr>
            <p:spPr>
              <a:xfrm>
                <a:off x="442604" y="427468"/>
                <a:ext cx="2054243" cy="369262"/>
              </a:xfrm>
              <a:prstGeom prst="rect">
                <a:avLst/>
              </a:prstGeom>
              <a:noFill/>
            </p:spPr>
            <p:txBody>
              <a:bodyPr wrap="square" rtlCol="1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0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W/O</a:t>
                </a: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 chemotherapy</a:t>
                </a:r>
                <a:endPara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  <p:sp>
            <p:nvSpPr>
              <p:cNvPr id="24" name="TextBox 9"/>
              <p:cNvSpPr txBox="1"/>
              <p:nvPr/>
            </p:nvSpPr>
            <p:spPr>
              <a:xfrm>
                <a:off x="2921727" y="437181"/>
                <a:ext cx="2610979" cy="369262"/>
              </a:xfrm>
              <a:prstGeom prst="rect">
                <a:avLst/>
              </a:prstGeom>
              <a:noFill/>
            </p:spPr>
            <p:txBody>
              <a:bodyPr wrap="square" rtlCol="1">
                <a:noAutofit/>
              </a:bodyPr>
              <a:lstStyle/>
              <a:p>
                <a:pPr>
                  <a:spcAft>
                    <a:spcPts val="0"/>
                  </a:spcAft>
                </a:pPr>
                <a:r>
                  <a:rPr lang="en-US" sz="1000" b="1" kern="1200" dirty="0">
                    <a:solidFill>
                      <a:srgbClr val="000000"/>
                    </a:solidFill>
                    <a:effectLst/>
                    <a:latin typeface="Calibri" panose="020F0502020204030204" pitchFamily="34" charset="0"/>
                    <a:ea typeface="Times New Roman" panose="02020603050405020304" pitchFamily="18" charset="0"/>
                    <a:cs typeface="Arial" panose="020B0604020202020204" pitchFamily="34" charset="0"/>
                  </a:rPr>
                  <a:t>W/chemotherapy</a:t>
                </a:r>
                <a:endParaRPr lang="en-US" sz="1600" b="1" dirty="0">
                  <a:effectLst/>
                  <a:latin typeface="Times New Roman" panose="02020603050405020304" pitchFamily="18" charset="0"/>
                  <a:ea typeface="Times New Roman" panose="02020603050405020304" pitchFamily="18" charset="0"/>
                </a:endParaRP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309846" y="5795994"/>
              <a:ext cx="3169510" cy="4276951"/>
              <a:chOff x="309846" y="5795994"/>
              <a:chExt cx="3169510" cy="4276951"/>
            </a:xfrm>
          </p:grpSpPr>
          <p:pic>
            <p:nvPicPr>
              <p:cNvPr id="16" name="Picture 15"/>
              <p:cNvPicPr>
                <a:picLocks noChangeAspect="1"/>
              </p:cNvPicPr>
              <p:nvPr/>
            </p:nvPicPr>
            <p:blipFill rotWithShape="1">
              <a:blip r:embed="rId5"/>
              <a:srcRect l="5471" t="5989" r="-1" b="4040"/>
              <a:stretch/>
            </p:blipFill>
            <p:spPr>
              <a:xfrm>
                <a:off x="831194" y="7585726"/>
                <a:ext cx="1264117" cy="1203158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 rotWithShape="1">
              <a:blip r:embed="rId6"/>
              <a:srcRect l="3822" t="5068" b="4192"/>
              <a:stretch/>
            </p:blipFill>
            <p:spPr>
              <a:xfrm>
                <a:off x="2130678" y="7557549"/>
                <a:ext cx="1288018" cy="1215190"/>
              </a:xfrm>
              <a:prstGeom prst="rect">
                <a:avLst/>
              </a:prstGeom>
            </p:spPr>
          </p:pic>
          <p:pic>
            <p:nvPicPr>
              <p:cNvPr id="28" name="Picture 27"/>
              <p:cNvPicPr>
                <a:picLocks noChangeAspect="1"/>
              </p:cNvPicPr>
              <p:nvPr/>
            </p:nvPicPr>
            <p:blipFill rotWithShape="1">
              <a:blip r:embed="rId7"/>
              <a:srcRect l="4785" t="5424" b="4734"/>
              <a:stretch/>
            </p:blipFill>
            <p:spPr>
              <a:xfrm>
                <a:off x="826709" y="8857754"/>
                <a:ext cx="1275103" cy="1203159"/>
              </a:xfrm>
              <a:prstGeom prst="rect">
                <a:avLst/>
              </a:prstGeom>
            </p:spPr>
          </p:pic>
          <p:pic>
            <p:nvPicPr>
              <p:cNvPr id="29" name="Picture 28"/>
              <p:cNvPicPr>
                <a:picLocks noChangeAspect="1"/>
              </p:cNvPicPr>
              <p:nvPr/>
            </p:nvPicPr>
            <p:blipFill rotWithShape="1">
              <a:blip r:embed="rId8"/>
              <a:srcRect l="3822" t="4433" b="3929"/>
              <a:stretch/>
            </p:blipFill>
            <p:spPr>
              <a:xfrm>
                <a:off x="2146575" y="8845723"/>
                <a:ext cx="1288018" cy="1227222"/>
              </a:xfrm>
              <a:prstGeom prst="rect">
                <a:avLst/>
              </a:prstGeom>
            </p:spPr>
          </p:pic>
          <p:sp>
            <p:nvSpPr>
              <p:cNvPr id="30" name="TextBox 29"/>
              <p:cNvSpPr txBox="1"/>
              <p:nvPr/>
            </p:nvSpPr>
            <p:spPr>
              <a:xfrm>
                <a:off x="361061" y="5795994"/>
                <a:ext cx="311918" cy="25289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200" b="1" dirty="0"/>
                  <a:t>A</a:t>
                </a:r>
                <a:endParaRPr lang="he-IL" sz="1200" b="1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309846" y="7435472"/>
                <a:ext cx="301259" cy="252892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200" b="1" dirty="0"/>
                  <a:t>C</a:t>
                </a:r>
                <a:endParaRPr lang="he-IL" sz="1200" b="1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188425" y="7397798"/>
                <a:ext cx="653750" cy="224793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0" b="1" dirty="0"/>
                  <a:t>Vehicle</a:t>
                </a:r>
                <a:endParaRPr lang="he-IL" sz="1000" b="1" dirty="0"/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584163" y="7390058"/>
                <a:ext cx="653750" cy="246221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0" b="1" dirty="0"/>
                  <a:t>VPA</a:t>
                </a:r>
                <a:endParaRPr lang="he-IL" sz="1000" b="1" dirty="0"/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127261" y="8683238"/>
                <a:ext cx="760429" cy="246221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0" b="1" dirty="0"/>
                  <a:t>Cisplatin</a:t>
                </a:r>
                <a:endParaRPr lang="he-IL" sz="1000" b="1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2270222" y="8678538"/>
                <a:ext cx="1209134" cy="246221"/>
              </a:xfrm>
              <a:prstGeom prst="rect">
                <a:avLst/>
              </a:prstGeom>
              <a:noFill/>
            </p:spPr>
            <p:txBody>
              <a:bodyPr wrap="square" rtlCol="1">
                <a:spAutoFit/>
              </a:bodyPr>
              <a:lstStyle/>
              <a:p>
                <a:r>
                  <a:rPr lang="en-US" sz="1000" b="1" dirty="0"/>
                  <a:t>Cisplatin &amp; VPA</a:t>
                </a:r>
                <a:endParaRPr lang="he-IL" sz="1000" b="1" dirty="0"/>
              </a:p>
            </p:txBody>
          </p:sp>
        </p:grpSp>
      </p:grpSp>
      <p:pic>
        <p:nvPicPr>
          <p:cNvPr id="53" name="Picture 4"/>
          <p:cNvPicPr>
            <a:picLocks noChangeAspect="1" noChangeArrowheads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003" r="31220" b="5214"/>
          <a:stretch/>
        </p:blipFill>
        <p:spPr bwMode="auto">
          <a:xfrm>
            <a:off x="98259" y="714535"/>
            <a:ext cx="1329947" cy="1211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2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t="5716" r="31009" b="5148"/>
          <a:stretch/>
        </p:blipFill>
        <p:spPr bwMode="auto">
          <a:xfrm>
            <a:off x="1802425" y="727986"/>
            <a:ext cx="1308152" cy="11930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64" name="Chart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44143969"/>
              </p:ext>
            </p:extLst>
          </p:nvPr>
        </p:nvGraphicFramePr>
        <p:xfrm>
          <a:off x="3717328" y="532312"/>
          <a:ext cx="3021880" cy="19230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65" name="TextBox 64"/>
          <p:cNvSpPr txBox="1"/>
          <p:nvPr/>
        </p:nvSpPr>
        <p:spPr>
          <a:xfrm>
            <a:off x="3292511" y="413174"/>
            <a:ext cx="223824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B</a:t>
            </a:r>
            <a:endParaRPr lang="he-IL" sz="1200" b="1" dirty="0"/>
          </a:p>
        </p:txBody>
      </p:sp>
      <p:sp>
        <p:nvSpPr>
          <p:cNvPr id="66" name="TextBox 65"/>
          <p:cNvSpPr txBox="1"/>
          <p:nvPr/>
        </p:nvSpPr>
        <p:spPr>
          <a:xfrm>
            <a:off x="600976" y="5064330"/>
            <a:ext cx="201090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JC-1 green fluorescence</a:t>
            </a:r>
            <a:endParaRPr lang="he-IL" b="1" dirty="0"/>
          </a:p>
        </p:txBody>
      </p:sp>
      <p:sp>
        <p:nvSpPr>
          <p:cNvPr id="67" name="TextBox 66"/>
          <p:cNvSpPr txBox="1"/>
          <p:nvPr/>
        </p:nvSpPr>
        <p:spPr>
          <a:xfrm rot="16200000">
            <a:off x="-557220" y="3811094"/>
            <a:ext cx="201090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/>
              <a:t>JC-1 red fluorescence</a:t>
            </a:r>
            <a:endParaRPr lang="he-IL" b="1" dirty="0"/>
          </a:p>
        </p:txBody>
      </p:sp>
      <p:cxnSp>
        <p:nvCxnSpPr>
          <p:cNvPr id="69" name="Straight Arrow Connector 68"/>
          <p:cNvCxnSpPr/>
          <p:nvPr/>
        </p:nvCxnSpPr>
        <p:spPr>
          <a:xfrm>
            <a:off x="1987751" y="5202838"/>
            <a:ext cx="1223128" cy="0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0" name="Straight Arrow Connector 69"/>
          <p:cNvCxnSpPr/>
          <p:nvPr/>
        </p:nvCxnSpPr>
        <p:spPr>
          <a:xfrm flipH="1" flipV="1">
            <a:off x="453985" y="2409554"/>
            <a:ext cx="7462" cy="1213736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pic>
        <p:nvPicPr>
          <p:cNvPr id="71" name="Picture 7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91439" y="5371964"/>
            <a:ext cx="2752483" cy="1801404"/>
          </a:xfrm>
          <a:prstGeom prst="rect">
            <a:avLst/>
          </a:prstGeom>
        </p:spPr>
      </p:pic>
      <p:sp>
        <p:nvSpPr>
          <p:cNvPr id="72" name="TextBox 71"/>
          <p:cNvSpPr txBox="1"/>
          <p:nvPr/>
        </p:nvSpPr>
        <p:spPr>
          <a:xfrm>
            <a:off x="166213" y="1899187"/>
            <a:ext cx="2010906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b="1" dirty="0">
                <a:solidFill>
                  <a:srgbClr val="000000"/>
                </a:solidFill>
                <a:ea typeface="Arial Unicode MS"/>
                <a:cs typeface="Times New Roman" panose="02020603050405020304" pitchFamily="18" charset="0"/>
              </a:rPr>
              <a:t>H2DCFH-DA </a:t>
            </a:r>
            <a:r>
              <a:rPr lang="en-US" sz="1000" b="1" dirty="0"/>
              <a:t>fluorescence</a:t>
            </a:r>
            <a:endParaRPr lang="he-IL" b="1" dirty="0"/>
          </a:p>
        </p:txBody>
      </p:sp>
      <p:cxnSp>
        <p:nvCxnSpPr>
          <p:cNvPr id="73" name="Straight Arrow Connector 72"/>
          <p:cNvCxnSpPr>
            <a:cxnSpLocks/>
          </p:cNvCxnSpPr>
          <p:nvPr/>
        </p:nvCxnSpPr>
        <p:spPr>
          <a:xfrm flipV="1">
            <a:off x="1678227" y="2020314"/>
            <a:ext cx="1532652" cy="1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3296833" y="413174"/>
            <a:ext cx="431137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B</a:t>
            </a:r>
            <a:endParaRPr lang="he-IL" sz="1200" b="1" dirty="0"/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1746" y="7283301"/>
            <a:ext cx="1440000" cy="1438045"/>
          </a:xfrm>
          <a:prstGeom prst="rect">
            <a:avLst/>
          </a:prstGeom>
        </p:spPr>
      </p:pic>
      <p:pic>
        <p:nvPicPr>
          <p:cNvPr id="85" name="Picture 84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4599" y="7287707"/>
            <a:ext cx="1440000" cy="1440001"/>
          </a:xfrm>
          <a:prstGeom prst="rect">
            <a:avLst/>
          </a:prstGeom>
        </p:spPr>
      </p:pic>
      <p:pic>
        <p:nvPicPr>
          <p:cNvPr id="86" name="Picture 85"/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4450" y="7287707"/>
            <a:ext cx="1440000" cy="1428967"/>
          </a:xfrm>
          <a:prstGeom prst="rect">
            <a:avLst/>
          </a:prstGeom>
        </p:spPr>
      </p:pic>
      <p:pic>
        <p:nvPicPr>
          <p:cNvPr id="87" name="Picture 86"/>
          <p:cNvPicPr>
            <a:picLocks noChangeAspect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09267" y="7276675"/>
            <a:ext cx="1440000" cy="1440000"/>
          </a:xfrm>
          <a:prstGeom prst="rect">
            <a:avLst/>
          </a:prstGeom>
        </p:spPr>
      </p:pic>
      <p:sp>
        <p:nvSpPr>
          <p:cNvPr id="89" name="TextBox 88"/>
          <p:cNvSpPr txBox="1"/>
          <p:nvPr/>
        </p:nvSpPr>
        <p:spPr>
          <a:xfrm>
            <a:off x="740847" y="8732011"/>
            <a:ext cx="1194492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/>
              <a:t>Vehicle</a:t>
            </a:r>
            <a:endParaRPr lang="he-IL" b="1" dirty="0"/>
          </a:p>
        </p:txBody>
      </p:sp>
      <p:sp>
        <p:nvSpPr>
          <p:cNvPr id="90" name="TextBox 89"/>
          <p:cNvSpPr txBox="1"/>
          <p:nvPr/>
        </p:nvSpPr>
        <p:spPr>
          <a:xfrm>
            <a:off x="2196160" y="8747309"/>
            <a:ext cx="1194492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/>
              <a:t>VPA</a:t>
            </a:r>
            <a:endParaRPr lang="he-IL" b="1" dirty="0"/>
          </a:p>
        </p:txBody>
      </p:sp>
      <p:sp>
        <p:nvSpPr>
          <p:cNvPr id="93" name="TextBox 92"/>
          <p:cNvSpPr txBox="1"/>
          <p:nvPr/>
        </p:nvSpPr>
        <p:spPr>
          <a:xfrm>
            <a:off x="3677898" y="8769545"/>
            <a:ext cx="1194492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/>
              <a:t>Cisplatin</a:t>
            </a:r>
            <a:endParaRPr lang="he-IL" b="1" dirty="0"/>
          </a:p>
        </p:txBody>
      </p:sp>
      <p:sp>
        <p:nvSpPr>
          <p:cNvPr id="94" name="TextBox 93"/>
          <p:cNvSpPr txBox="1"/>
          <p:nvPr/>
        </p:nvSpPr>
        <p:spPr>
          <a:xfrm>
            <a:off x="5109267" y="8747309"/>
            <a:ext cx="1194492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/>
              <a:t>Cisplatin &amp; VPA</a:t>
            </a:r>
            <a:endParaRPr lang="he-IL" b="1" dirty="0"/>
          </a:p>
        </p:txBody>
      </p:sp>
      <p:sp>
        <p:nvSpPr>
          <p:cNvPr id="95" name="TextBox 32"/>
          <p:cNvSpPr txBox="1"/>
          <p:nvPr/>
        </p:nvSpPr>
        <p:spPr>
          <a:xfrm>
            <a:off x="101719" y="5310551"/>
            <a:ext cx="38972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E</a:t>
            </a:r>
            <a:endParaRPr lang="he-IL" sz="1200" b="1" dirty="0"/>
          </a:p>
        </p:txBody>
      </p:sp>
      <p:sp>
        <p:nvSpPr>
          <p:cNvPr id="96" name="TextBox 32"/>
          <p:cNvSpPr txBox="1"/>
          <p:nvPr/>
        </p:nvSpPr>
        <p:spPr>
          <a:xfrm>
            <a:off x="41151" y="7138175"/>
            <a:ext cx="34756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0" b="1" dirty="0"/>
              <a:t>G</a:t>
            </a:r>
            <a:endParaRPr lang="he-IL" sz="1200" b="1" dirty="0"/>
          </a:p>
        </p:txBody>
      </p:sp>
      <p:cxnSp>
        <p:nvCxnSpPr>
          <p:cNvPr id="3" name="Straight Connector 2"/>
          <p:cNvCxnSpPr/>
          <p:nvPr/>
        </p:nvCxnSpPr>
        <p:spPr>
          <a:xfrm>
            <a:off x="4570447" y="944176"/>
            <a:ext cx="12691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48" name="TextBox 1"/>
          <p:cNvSpPr txBox="1"/>
          <p:nvPr/>
        </p:nvSpPr>
        <p:spPr>
          <a:xfrm>
            <a:off x="5204997" y="2575234"/>
            <a:ext cx="425420" cy="150961"/>
          </a:xfrm>
          <a:prstGeom prst="rect">
            <a:avLst/>
          </a:prstGeom>
        </p:spPr>
        <p:txBody>
          <a:bodyPr wrap="square" rtlCol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he-IL" sz="1500" b="1" dirty="0">
                <a:latin typeface="Calibri"/>
              </a:rPr>
              <a:t>*</a:t>
            </a:r>
            <a:endParaRPr lang="he-IL" sz="1500" b="1" dirty="0"/>
          </a:p>
        </p:txBody>
      </p:sp>
      <p:sp>
        <p:nvSpPr>
          <p:cNvPr id="49" name="TextBox 1"/>
          <p:cNvSpPr txBox="1"/>
          <p:nvPr/>
        </p:nvSpPr>
        <p:spPr>
          <a:xfrm>
            <a:off x="5005660" y="2737521"/>
            <a:ext cx="425420" cy="150961"/>
          </a:xfrm>
          <a:prstGeom prst="rect">
            <a:avLst/>
          </a:prstGeom>
        </p:spPr>
        <p:txBody>
          <a:bodyPr wrap="square" rtlCol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he-IL" sz="1500" b="1" dirty="0">
                <a:latin typeface="Calibri"/>
              </a:rPr>
              <a:t>*</a:t>
            </a:r>
            <a:endParaRPr lang="he-IL" sz="1500" b="1" dirty="0"/>
          </a:p>
        </p:txBody>
      </p:sp>
      <p:sp>
        <p:nvSpPr>
          <p:cNvPr id="50" name="TextBox 1"/>
          <p:cNvSpPr txBox="1"/>
          <p:nvPr/>
        </p:nvSpPr>
        <p:spPr>
          <a:xfrm>
            <a:off x="4544539" y="3050348"/>
            <a:ext cx="425420" cy="150961"/>
          </a:xfrm>
          <a:prstGeom prst="rect">
            <a:avLst/>
          </a:prstGeom>
        </p:spPr>
        <p:txBody>
          <a:bodyPr wrap="square" rtlCol="1"/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he-IL" sz="1500" b="1" dirty="0">
                <a:latin typeface="Calibri"/>
              </a:rPr>
              <a:t>*</a:t>
            </a:r>
            <a:endParaRPr lang="he-IL" sz="15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2670396" y="2028516"/>
            <a:ext cx="412766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D</a:t>
            </a:r>
            <a:endParaRPr lang="he-IL" sz="1200" b="1" dirty="0"/>
          </a:p>
        </p:txBody>
      </p:sp>
      <p:grpSp>
        <p:nvGrpSpPr>
          <p:cNvPr id="52" name="Group 51"/>
          <p:cNvGrpSpPr/>
          <p:nvPr/>
        </p:nvGrpSpPr>
        <p:grpSpPr>
          <a:xfrm>
            <a:off x="1409849" y="704902"/>
            <a:ext cx="543679" cy="469788"/>
            <a:chOff x="750627" y="1269085"/>
            <a:chExt cx="529910" cy="502664"/>
          </a:xfrm>
        </p:grpSpPr>
        <p:sp>
          <p:nvSpPr>
            <p:cNvPr id="54" name="Rectangle 53"/>
            <p:cNvSpPr/>
            <p:nvPr/>
          </p:nvSpPr>
          <p:spPr>
            <a:xfrm>
              <a:off x="750627" y="1321624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783285" y="1269085"/>
              <a:ext cx="497252" cy="21544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800" b="1" dirty="0"/>
                <a:t>Vehicle</a:t>
              </a:r>
              <a:endParaRPr lang="he-IL" sz="800" b="1" dirty="0"/>
            </a:p>
          </p:txBody>
        </p:sp>
        <p:sp>
          <p:nvSpPr>
            <p:cNvPr id="57" name="Rectangle 56"/>
            <p:cNvSpPr/>
            <p:nvPr/>
          </p:nvSpPr>
          <p:spPr>
            <a:xfrm>
              <a:off x="756138" y="1461463"/>
              <a:ext cx="108000" cy="108000"/>
            </a:xfrm>
            <a:prstGeom prst="rect">
              <a:avLst/>
            </a:prstGeom>
            <a:solidFill>
              <a:srgbClr val="3333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83911" y="1409503"/>
              <a:ext cx="420599" cy="362246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800" b="1" dirty="0"/>
                <a:t>1 </a:t>
              </a:r>
              <a:r>
                <a:rPr lang="en-US" sz="800" b="1" dirty="0" err="1"/>
                <a:t>mM</a:t>
              </a:r>
              <a:endParaRPr lang="en-US" sz="800" b="1" dirty="0"/>
            </a:p>
            <a:p>
              <a:r>
                <a:rPr lang="en-US" sz="800" b="1" dirty="0"/>
                <a:t> VPA</a:t>
              </a:r>
              <a:endParaRPr lang="he-IL" sz="800" b="1" dirty="0"/>
            </a:p>
          </p:txBody>
        </p:sp>
      </p:grpSp>
      <p:grpSp>
        <p:nvGrpSpPr>
          <p:cNvPr id="78" name="Group 77"/>
          <p:cNvGrpSpPr/>
          <p:nvPr/>
        </p:nvGrpSpPr>
        <p:grpSpPr>
          <a:xfrm>
            <a:off x="3083162" y="710468"/>
            <a:ext cx="955174" cy="610686"/>
            <a:chOff x="750627" y="1276035"/>
            <a:chExt cx="906651" cy="625632"/>
          </a:xfrm>
        </p:grpSpPr>
        <p:sp>
          <p:nvSpPr>
            <p:cNvPr id="79" name="Rectangle 78"/>
            <p:cNvSpPr/>
            <p:nvPr/>
          </p:nvSpPr>
          <p:spPr>
            <a:xfrm>
              <a:off x="750627" y="1321624"/>
              <a:ext cx="108000" cy="108000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806941" y="1276035"/>
              <a:ext cx="497252" cy="21544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800" b="1" dirty="0"/>
                <a:t>Vehicle</a:t>
              </a:r>
              <a:endParaRPr lang="he-IL" sz="800" b="1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756138" y="1461463"/>
              <a:ext cx="108000" cy="108000"/>
            </a:xfrm>
            <a:prstGeom prst="rect">
              <a:avLst/>
            </a:prstGeom>
            <a:solidFill>
              <a:srgbClr val="00FF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88" name="Rectangle 87"/>
            <p:cNvSpPr/>
            <p:nvPr/>
          </p:nvSpPr>
          <p:spPr>
            <a:xfrm>
              <a:off x="750627" y="1611786"/>
              <a:ext cx="108000" cy="108000"/>
            </a:xfrm>
            <a:prstGeom prst="rect">
              <a:avLst/>
            </a:prstGeom>
            <a:solidFill>
              <a:srgbClr val="FF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1" anchor="ctr"/>
            <a:lstStyle/>
            <a:p>
              <a:pPr algn="ctr"/>
              <a:endParaRPr lang="he-IL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808969" y="1415074"/>
              <a:ext cx="848309" cy="21544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800" b="1" dirty="0"/>
                <a:t>10 µM Cisplatin</a:t>
              </a:r>
              <a:endParaRPr lang="he-IL" sz="800" b="1" dirty="0"/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804627" y="1563113"/>
              <a:ext cx="848309" cy="338554"/>
            </a:xfrm>
            <a:prstGeom prst="rect">
              <a:avLst/>
            </a:prstGeom>
            <a:noFill/>
          </p:spPr>
          <p:txBody>
            <a:bodyPr wrap="none" rtlCol="1">
              <a:spAutoFit/>
            </a:bodyPr>
            <a:lstStyle/>
            <a:p>
              <a:r>
                <a:rPr lang="en-US" sz="800" b="1" dirty="0"/>
                <a:t>10 µM Cisplatin</a:t>
              </a:r>
            </a:p>
            <a:p>
              <a:r>
                <a:rPr lang="en-US" sz="800" b="1" dirty="0"/>
                <a:t> &amp; 1 mM VPA</a:t>
              </a:r>
              <a:endParaRPr lang="he-IL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6792436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76985382"/>
              </p:ext>
            </p:extLst>
          </p:nvPr>
        </p:nvGraphicFramePr>
        <p:xfrm>
          <a:off x="1014153" y="576929"/>
          <a:ext cx="4268746" cy="34796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Rectangle 3"/>
          <p:cNvSpPr/>
          <p:nvPr/>
        </p:nvSpPr>
        <p:spPr>
          <a:xfrm>
            <a:off x="233719" y="6523631"/>
            <a:ext cx="6153433" cy="14619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0"/>
              </a:spcAft>
            </a:pPr>
            <a:r>
              <a:rPr lang="en-US" sz="1200" b="1" dirty="0">
                <a:solidFill>
                  <a:srgbClr val="000000"/>
                </a:solidFill>
                <a:ea typeface="Arial Unicode MS"/>
                <a:cs typeface="+mj-cs"/>
              </a:rPr>
              <a:t>Supplementary Figure 3</a:t>
            </a:r>
            <a:r>
              <a:rPr lang="en-US" sz="1200" dirty="0">
                <a:solidFill>
                  <a:srgbClr val="000000"/>
                </a:solidFill>
                <a:ea typeface="Arial Unicode MS"/>
                <a:cs typeface="+mj-cs"/>
              </a:rPr>
              <a:t>.  (A) TNBC pleural effusion-derived tumor organoids were treated with 3 µM cisplatin, 7 µM paclitaxel, 10 µM disulfiram, 1 </a:t>
            </a:r>
            <a:r>
              <a:rPr lang="en-US" sz="1200" dirty="0" err="1">
                <a:solidFill>
                  <a:srgbClr val="000000"/>
                </a:solidFill>
                <a:ea typeface="Arial Unicode MS"/>
                <a:cs typeface="+mj-cs"/>
              </a:rPr>
              <a:t>mM</a:t>
            </a:r>
            <a:r>
              <a:rPr lang="en-US" sz="1200" dirty="0">
                <a:solidFill>
                  <a:srgbClr val="000000"/>
                </a:solidFill>
                <a:ea typeface="Arial Unicode MS"/>
                <a:cs typeface="+mj-cs"/>
              </a:rPr>
              <a:t> VPA, 5 µM </a:t>
            </a:r>
            <a:r>
              <a:rPr lang="en-US" sz="1200" dirty="0" err="1">
                <a:solidFill>
                  <a:srgbClr val="000000"/>
                </a:solidFill>
                <a:ea typeface="Arial Unicode MS"/>
                <a:cs typeface="+mj-cs"/>
              </a:rPr>
              <a:t>entinostat</a:t>
            </a:r>
            <a:r>
              <a:rPr lang="en-US" sz="1200" dirty="0">
                <a:solidFill>
                  <a:srgbClr val="000000"/>
                </a:solidFill>
                <a:ea typeface="Arial Unicode MS"/>
                <a:cs typeface="+mj-cs"/>
              </a:rPr>
              <a:t> and µM </a:t>
            </a:r>
            <a:r>
              <a:rPr lang="en-US" sz="1200" dirty="0" err="1">
                <a:solidFill>
                  <a:srgbClr val="000000"/>
                </a:solidFill>
                <a:ea typeface="Arial Unicode MS"/>
                <a:cs typeface="+mj-cs"/>
              </a:rPr>
              <a:t>talazoparib</a:t>
            </a:r>
            <a:r>
              <a:rPr lang="en-US" sz="1200" dirty="0">
                <a:solidFill>
                  <a:srgbClr val="000000"/>
                </a:solidFill>
                <a:ea typeface="Arial Unicode MS"/>
                <a:cs typeface="+mj-cs"/>
              </a:rPr>
              <a:t> for 5 days, followed by the XTT assay for cellular viability. Results are presented as percent of control (mean ± SD]) (N=2/group).(B) Same TNBC organoids were treated with  VPA, cisplatin, Taxol or both for 72 hr </a:t>
            </a:r>
            <a:r>
              <a:rPr lang="en-US" sz="1200" dirty="0">
                <a:solidFill>
                  <a:srgbClr val="000000"/>
                </a:solidFill>
                <a:ea typeface="Arial Unicode MS"/>
              </a:rPr>
              <a:t>. Results are presented as percent of control (mean ± SD); *p &lt; 0.05 (N=4/group)</a:t>
            </a:r>
          </a:p>
          <a:p>
            <a:pPr algn="just">
              <a:spcBef>
                <a:spcPts val="600"/>
              </a:spcBef>
              <a:spcAft>
                <a:spcPts val="0"/>
              </a:spcAft>
            </a:pPr>
            <a:endParaRPr lang="en-US" sz="1200" dirty="0">
              <a:solidFill>
                <a:srgbClr val="000000"/>
              </a:solidFill>
              <a:ea typeface="Arial Unicode MS"/>
              <a:cs typeface="+mj-cs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594762" y="438429"/>
            <a:ext cx="320601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b="1" dirty="0"/>
              <a:t>A</a:t>
            </a:r>
            <a:endParaRPr lang="he-IL" sz="1200" b="1" dirty="0"/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18906083"/>
              </p:ext>
            </p:extLst>
          </p:nvPr>
        </p:nvGraphicFramePr>
        <p:xfrm>
          <a:off x="1014153" y="4056611"/>
          <a:ext cx="4550711" cy="24670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9908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8595</TotalTime>
  <Words>596</Words>
  <Application>Microsoft Office PowerPoint</Application>
  <PresentationFormat>Widescreen</PresentationFormat>
  <Paragraphs>90</Paragraphs>
  <Slides>3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rial</vt:lpstr>
      <vt:lpstr>Arial Unicode MS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גרנית מזרחי אביטל - GRANIT MIZRAHI AVITAL</dc:creator>
  <cp:lastModifiedBy>גרנית מזרחי אביטל - GRANIT MIZRAHI AVITAL</cp:lastModifiedBy>
  <cp:revision>260</cp:revision>
  <dcterms:created xsi:type="dcterms:W3CDTF">2021-01-17T00:33:21Z</dcterms:created>
  <dcterms:modified xsi:type="dcterms:W3CDTF">2023-08-26T12:03:40Z</dcterms:modified>
</cp:coreProperties>
</file>